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6"/>
  </p:notesMasterIdLst>
  <p:sldIdLst>
    <p:sldId id="309" r:id="rId5"/>
  </p:sldIdLst>
  <p:sldSz cx="6858000" cy="9906000" type="A4"/>
  <p:notesSz cx="7315200" cy="96012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33CC"/>
    <a:srgbClr val="CC9900"/>
    <a:srgbClr val="FFCC00"/>
    <a:srgbClr val="FFFFFF"/>
    <a:srgbClr val="E8B7B7"/>
    <a:srgbClr val="A8CDD7"/>
    <a:srgbClr val="FF505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p:restoredTop sz="95161" autoAdjust="0"/>
  </p:normalViewPr>
  <p:slideViewPr>
    <p:cSldViewPr snapToGrid="0">
      <p:cViewPr varScale="1">
        <p:scale>
          <a:sx n="71" d="100"/>
          <a:sy n="71" d="100"/>
        </p:scale>
        <p:origin x="1446"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ra Weis" userId="6a51f4e6-0e93-4a18-834c-a49e1ed77407" providerId="ADAL" clId="{6959E033-7E6A-4EA0-AB19-75F676599088}"/>
    <pc:docChg chg="undo custSel addSld modSld">
      <pc:chgData name="Sara Weis" userId="6a51f4e6-0e93-4a18-834c-a49e1ed77407" providerId="ADAL" clId="{6959E033-7E6A-4EA0-AB19-75F676599088}" dt="2025-01-02T17:18:45.578" v="422" actId="1076"/>
      <pc:docMkLst>
        <pc:docMk/>
      </pc:docMkLst>
      <pc:sldChg chg="addSp delSp modSp">
        <pc:chgData name="Sara Weis" userId="6a51f4e6-0e93-4a18-834c-a49e1ed77407" providerId="ADAL" clId="{6959E033-7E6A-4EA0-AB19-75F676599088}" dt="2025-01-02T17:15:24.765" v="382" actId="20577"/>
        <pc:sldMkLst>
          <pc:docMk/>
          <pc:sldMk cId="2106248321" sldId="298"/>
        </pc:sldMkLst>
        <pc:spChg chg="add mod">
          <ac:chgData name="Sara Weis" userId="6a51f4e6-0e93-4a18-834c-a49e1ed77407" providerId="ADAL" clId="{6959E033-7E6A-4EA0-AB19-75F676599088}" dt="2025-01-02T17:15:24.765" v="382" actId="20577"/>
          <ac:spMkLst>
            <pc:docMk/>
            <pc:sldMk cId="2106248321" sldId="298"/>
            <ac:spMk id="3" creationId="{F85F01AF-E2FC-4A20-BC96-820C3267DBD5}"/>
          </ac:spMkLst>
        </pc:spChg>
        <pc:spChg chg="mod">
          <ac:chgData name="Sara Weis" userId="6a51f4e6-0e93-4a18-834c-a49e1ed77407" providerId="ADAL" clId="{6959E033-7E6A-4EA0-AB19-75F676599088}" dt="2025-01-02T16:56:55.861" v="67" actId="122"/>
          <ac:spMkLst>
            <pc:docMk/>
            <pc:sldMk cId="2106248321" sldId="298"/>
            <ac:spMk id="9" creationId="{75936999-04B7-4CA0-96C9-CD97C06BD1F1}"/>
          </ac:spMkLst>
        </pc:spChg>
        <pc:spChg chg="mod">
          <ac:chgData name="Sara Weis" userId="6a51f4e6-0e93-4a18-834c-a49e1ed77407" providerId="ADAL" clId="{6959E033-7E6A-4EA0-AB19-75F676599088}" dt="2025-01-02T16:56:55.861" v="67" actId="122"/>
          <ac:spMkLst>
            <pc:docMk/>
            <pc:sldMk cId="2106248321" sldId="298"/>
            <ac:spMk id="10" creationId="{98561D18-56B5-4A22-B657-19C0C43B029A}"/>
          </ac:spMkLst>
        </pc:spChg>
        <pc:spChg chg="mod">
          <ac:chgData name="Sara Weis" userId="6a51f4e6-0e93-4a18-834c-a49e1ed77407" providerId="ADAL" clId="{6959E033-7E6A-4EA0-AB19-75F676599088}" dt="2025-01-02T16:56:55.861" v="67" actId="122"/>
          <ac:spMkLst>
            <pc:docMk/>
            <pc:sldMk cId="2106248321" sldId="298"/>
            <ac:spMk id="11" creationId="{06F6387F-5DC2-44EE-B710-A3F4811AD05E}"/>
          </ac:spMkLst>
        </pc:spChg>
        <pc:spChg chg="mod">
          <ac:chgData name="Sara Weis" userId="6a51f4e6-0e93-4a18-834c-a49e1ed77407" providerId="ADAL" clId="{6959E033-7E6A-4EA0-AB19-75F676599088}" dt="2025-01-02T16:56:55.861" v="67" actId="122"/>
          <ac:spMkLst>
            <pc:docMk/>
            <pc:sldMk cId="2106248321" sldId="298"/>
            <ac:spMk id="12" creationId="{B599E299-20AD-4B90-863E-C9F21A3FC407}"/>
          </ac:spMkLst>
        </pc:spChg>
        <pc:spChg chg="mod">
          <ac:chgData name="Sara Weis" userId="6a51f4e6-0e93-4a18-834c-a49e1ed77407" providerId="ADAL" clId="{6959E033-7E6A-4EA0-AB19-75F676599088}" dt="2025-01-02T16:56:55.861" v="67" actId="122"/>
          <ac:spMkLst>
            <pc:docMk/>
            <pc:sldMk cId="2106248321" sldId="298"/>
            <ac:spMk id="19" creationId="{236DD729-0233-4845-B1E1-FF2549A9C872}"/>
          </ac:spMkLst>
        </pc:spChg>
        <pc:spChg chg="mod">
          <ac:chgData name="Sara Weis" userId="6a51f4e6-0e93-4a18-834c-a49e1ed77407" providerId="ADAL" clId="{6959E033-7E6A-4EA0-AB19-75F676599088}" dt="2025-01-02T16:56:55.861" v="67" actId="122"/>
          <ac:spMkLst>
            <pc:docMk/>
            <pc:sldMk cId="2106248321" sldId="298"/>
            <ac:spMk id="20" creationId="{87F2151C-91AE-444F-BA0A-F5DE6A8495AA}"/>
          </ac:spMkLst>
        </pc:spChg>
        <pc:spChg chg="mod">
          <ac:chgData name="Sara Weis" userId="6a51f4e6-0e93-4a18-834c-a49e1ed77407" providerId="ADAL" clId="{6959E033-7E6A-4EA0-AB19-75F676599088}" dt="2025-01-02T17:08:03.483" v="375" actId="1076"/>
          <ac:spMkLst>
            <pc:docMk/>
            <pc:sldMk cId="2106248321" sldId="298"/>
            <ac:spMk id="23" creationId="{9837469B-6902-495A-86E3-722D7C6A57DC}"/>
          </ac:spMkLst>
        </pc:spChg>
        <pc:spChg chg="del">
          <ac:chgData name="Sara Weis" userId="6a51f4e6-0e93-4a18-834c-a49e1ed77407" providerId="ADAL" clId="{6959E033-7E6A-4EA0-AB19-75F676599088}" dt="2025-01-02T17:05:57.477" v="359" actId="478"/>
          <ac:spMkLst>
            <pc:docMk/>
            <pc:sldMk cId="2106248321" sldId="298"/>
            <ac:spMk id="45" creationId="{F3A9156C-C54C-4614-ABB9-5AF095F0F775}"/>
          </ac:spMkLst>
        </pc:spChg>
        <pc:spChg chg="mod">
          <ac:chgData name="Sara Weis" userId="6a51f4e6-0e93-4a18-834c-a49e1ed77407" providerId="ADAL" clId="{6959E033-7E6A-4EA0-AB19-75F676599088}" dt="2025-01-02T16:57:01.182" v="68" actId="1076"/>
          <ac:spMkLst>
            <pc:docMk/>
            <pc:sldMk cId="2106248321" sldId="298"/>
            <ac:spMk id="56" creationId="{1CE285CC-DC0D-4825-9EDF-E3D5D8427719}"/>
          </ac:spMkLst>
        </pc:spChg>
        <pc:spChg chg="mod">
          <ac:chgData name="Sara Weis" userId="6a51f4e6-0e93-4a18-834c-a49e1ed77407" providerId="ADAL" clId="{6959E033-7E6A-4EA0-AB19-75F676599088}" dt="2025-01-02T17:08:03.483" v="375" actId="1076"/>
          <ac:spMkLst>
            <pc:docMk/>
            <pc:sldMk cId="2106248321" sldId="298"/>
            <ac:spMk id="70" creationId="{7A30D47F-4FE9-4840-9977-6022DD4A371A}"/>
          </ac:spMkLst>
        </pc:spChg>
        <pc:spChg chg="mod">
          <ac:chgData name="Sara Weis" userId="6a51f4e6-0e93-4a18-834c-a49e1ed77407" providerId="ADAL" clId="{6959E033-7E6A-4EA0-AB19-75F676599088}" dt="2025-01-02T16:56:55.861" v="67" actId="122"/>
          <ac:spMkLst>
            <pc:docMk/>
            <pc:sldMk cId="2106248321" sldId="298"/>
            <ac:spMk id="76" creationId="{3F6D0F30-184D-40C5-AF9D-82030B65FD09}"/>
          </ac:spMkLst>
        </pc:spChg>
        <pc:spChg chg="mod">
          <ac:chgData name="Sara Weis" userId="6a51f4e6-0e93-4a18-834c-a49e1ed77407" providerId="ADAL" clId="{6959E033-7E6A-4EA0-AB19-75F676599088}" dt="2025-01-02T16:56:55.861" v="67" actId="122"/>
          <ac:spMkLst>
            <pc:docMk/>
            <pc:sldMk cId="2106248321" sldId="298"/>
            <ac:spMk id="77" creationId="{8CB2C145-4003-477F-81BA-EEA2846A0D4F}"/>
          </ac:spMkLst>
        </pc:spChg>
        <pc:spChg chg="mod">
          <ac:chgData name="Sara Weis" userId="6a51f4e6-0e93-4a18-834c-a49e1ed77407" providerId="ADAL" clId="{6959E033-7E6A-4EA0-AB19-75F676599088}" dt="2025-01-02T16:56:55.861" v="67" actId="122"/>
          <ac:spMkLst>
            <pc:docMk/>
            <pc:sldMk cId="2106248321" sldId="298"/>
            <ac:spMk id="78" creationId="{5B67D640-44A5-4C40-8143-D52616D97BD9}"/>
          </ac:spMkLst>
        </pc:spChg>
        <pc:spChg chg="mod">
          <ac:chgData name="Sara Weis" userId="6a51f4e6-0e93-4a18-834c-a49e1ed77407" providerId="ADAL" clId="{6959E033-7E6A-4EA0-AB19-75F676599088}" dt="2025-01-02T16:56:55.861" v="67" actId="122"/>
          <ac:spMkLst>
            <pc:docMk/>
            <pc:sldMk cId="2106248321" sldId="298"/>
            <ac:spMk id="84" creationId="{B5744F81-4DF0-4530-87BD-B543F756DD8F}"/>
          </ac:spMkLst>
        </pc:spChg>
        <pc:spChg chg="mod">
          <ac:chgData name="Sara Weis" userId="6a51f4e6-0e93-4a18-834c-a49e1ed77407" providerId="ADAL" clId="{6959E033-7E6A-4EA0-AB19-75F676599088}" dt="2025-01-02T16:56:55.861" v="67" actId="122"/>
          <ac:spMkLst>
            <pc:docMk/>
            <pc:sldMk cId="2106248321" sldId="298"/>
            <ac:spMk id="85" creationId="{D04BE4A0-467D-4070-B64B-9F2C118EF847}"/>
          </ac:spMkLst>
        </pc:spChg>
        <pc:spChg chg="mod">
          <ac:chgData name="Sara Weis" userId="6a51f4e6-0e93-4a18-834c-a49e1ed77407" providerId="ADAL" clId="{6959E033-7E6A-4EA0-AB19-75F676599088}" dt="2025-01-02T16:56:55.861" v="67" actId="122"/>
          <ac:spMkLst>
            <pc:docMk/>
            <pc:sldMk cId="2106248321" sldId="298"/>
            <ac:spMk id="86" creationId="{98515101-AB5F-4E78-A682-FFAEA0B99110}"/>
          </ac:spMkLst>
        </pc:spChg>
        <pc:spChg chg="mod">
          <ac:chgData name="Sara Weis" userId="6a51f4e6-0e93-4a18-834c-a49e1ed77407" providerId="ADAL" clId="{6959E033-7E6A-4EA0-AB19-75F676599088}" dt="2025-01-02T16:56:55.861" v="67" actId="122"/>
          <ac:spMkLst>
            <pc:docMk/>
            <pc:sldMk cId="2106248321" sldId="298"/>
            <ac:spMk id="88" creationId="{5C118BE6-EAB6-49A0-8589-3C1535D4CA55}"/>
          </ac:spMkLst>
        </pc:spChg>
        <pc:spChg chg="mod">
          <ac:chgData name="Sara Weis" userId="6a51f4e6-0e93-4a18-834c-a49e1ed77407" providerId="ADAL" clId="{6959E033-7E6A-4EA0-AB19-75F676599088}" dt="2025-01-02T16:57:10.910" v="87" actId="1035"/>
          <ac:spMkLst>
            <pc:docMk/>
            <pc:sldMk cId="2106248321" sldId="298"/>
            <ac:spMk id="94" creationId="{2650BDE5-AD2F-42F9-A372-1968EC006B7E}"/>
          </ac:spMkLst>
        </pc:spChg>
        <pc:grpChg chg="add mod">
          <ac:chgData name="Sara Weis" userId="6a51f4e6-0e93-4a18-834c-a49e1ed77407" providerId="ADAL" clId="{6959E033-7E6A-4EA0-AB19-75F676599088}" dt="2025-01-02T17:08:09.193" v="377" actId="14100"/>
          <ac:grpSpMkLst>
            <pc:docMk/>
            <pc:sldMk cId="2106248321" sldId="298"/>
            <ac:grpSpMk id="2" creationId="{960064E3-9BEA-4925-8610-BCA826CE0C41}"/>
          </ac:grpSpMkLst>
        </pc:grpChg>
        <pc:grpChg chg="mod">
          <ac:chgData name="Sara Weis" userId="6a51f4e6-0e93-4a18-834c-a49e1ed77407" providerId="ADAL" clId="{6959E033-7E6A-4EA0-AB19-75F676599088}" dt="2025-01-02T16:56:35.670" v="63" actId="164"/>
          <ac:grpSpMkLst>
            <pc:docMk/>
            <pc:sldMk cId="2106248321" sldId="298"/>
            <ac:grpSpMk id="18" creationId="{6C3C0227-C401-42B7-83D7-5BCA28C7679E}"/>
          </ac:grpSpMkLst>
        </pc:grpChg>
        <pc:grpChg chg="mod">
          <ac:chgData name="Sara Weis" userId="6a51f4e6-0e93-4a18-834c-a49e1ed77407" providerId="ADAL" clId="{6959E033-7E6A-4EA0-AB19-75F676599088}" dt="2025-01-02T16:56:35.670" v="63" actId="164"/>
          <ac:grpSpMkLst>
            <pc:docMk/>
            <pc:sldMk cId="2106248321" sldId="298"/>
            <ac:grpSpMk id="24" creationId="{D5F64F85-735E-4924-B238-3BB390ADA6D2}"/>
          </ac:grpSpMkLst>
        </pc:grpChg>
        <pc:cxnChg chg="mod">
          <ac:chgData name="Sara Weis" userId="6a51f4e6-0e93-4a18-834c-a49e1ed77407" providerId="ADAL" clId="{6959E033-7E6A-4EA0-AB19-75F676599088}" dt="2025-01-02T16:56:35.670" v="63" actId="164"/>
          <ac:cxnSpMkLst>
            <pc:docMk/>
            <pc:sldMk cId="2106248321" sldId="298"/>
            <ac:cxnSpMk id="55" creationId="{444086A9-B7E4-41B3-B776-3280FA8A5349}"/>
          </ac:cxnSpMkLst>
        </pc:cxnChg>
        <pc:cxnChg chg="mod">
          <ac:chgData name="Sara Weis" userId="6a51f4e6-0e93-4a18-834c-a49e1ed77407" providerId="ADAL" clId="{6959E033-7E6A-4EA0-AB19-75F676599088}" dt="2025-01-02T16:57:10.910" v="87" actId="1035"/>
          <ac:cxnSpMkLst>
            <pc:docMk/>
            <pc:sldMk cId="2106248321" sldId="298"/>
            <ac:cxnSpMk id="93" creationId="{DBB2319C-3D95-4D00-AFE1-D23979B8E566}"/>
          </ac:cxnSpMkLst>
        </pc:cxnChg>
      </pc:sldChg>
      <pc:sldChg chg="addSp delSp modSp">
        <pc:chgData name="Sara Weis" userId="6a51f4e6-0e93-4a18-834c-a49e1ed77407" providerId="ADAL" clId="{6959E033-7E6A-4EA0-AB19-75F676599088}" dt="2025-01-02T17:18:45.578" v="422" actId="1076"/>
        <pc:sldMkLst>
          <pc:docMk/>
          <pc:sldMk cId="1407140874" sldId="309"/>
        </pc:sldMkLst>
        <pc:spChg chg="add mod">
          <ac:chgData name="Sara Weis" userId="6a51f4e6-0e93-4a18-834c-a49e1ed77407" providerId="ADAL" clId="{6959E033-7E6A-4EA0-AB19-75F676599088}" dt="2025-01-02T17:16:14.495" v="386" actId="403"/>
          <ac:spMkLst>
            <pc:docMk/>
            <pc:sldMk cId="1407140874" sldId="309"/>
            <ac:spMk id="3" creationId="{442AB1F2-5941-4F44-AC8D-E4A87AD7535C}"/>
          </ac:spMkLst>
        </pc:spChg>
        <pc:spChg chg="del">
          <ac:chgData name="Sara Weis" userId="6a51f4e6-0e93-4a18-834c-a49e1ed77407" providerId="ADAL" clId="{6959E033-7E6A-4EA0-AB19-75F676599088}" dt="2025-01-02T16:58:07.845" v="111" actId="478"/>
          <ac:spMkLst>
            <pc:docMk/>
            <pc:sldMk cId="1407140874" sldId="309"/>
            <ac:spMk id="5" creationId="{B847A6B5-FE3F-456F-A592-96E2D8DDCCD8}"/>
          </ac:spMkLst>
        </pc:spChg>
        <pc:spChg chg="mod topLvl">
          <ac:chgData name="Sara Weis" userId="6a51f4e6-0e93-4a18-834c-a49e1ed77407" providerId="ADAL" clId="{6959E033-7E6A-4EA0-AB19-75F676599088}" dt="2025-01-02T17:00:26.168" v="180" actId="164"/>
          <ac:spMkLst>
            <pc:docMk/>
            <pc:sldMk cId="1407140874" sldId="309"/>
            <ac:spMk id="7" creationId="{65344804-014D-4F7F-89BE-8FDBDC89E59A}"/>
          </ac:spMkLst>
        </pc:spChg>
        <pc:spChg chg="mod topLvl">
          <ac:chgData name="Sara Weis" userId="6a51f4e6-0e93-4a18-834c-a49e1ed77407" providerId="ADAL" clId="{6959E033-7E6A-4EA0-AB19-75F676599088}" dt="2025-01-02T17:00:26.168" v="180" actId="164"/>
          <ac:spMkLst>
            <pc:docMk/>
            <pc:sldMk cId="1407140874" sldId="309"/>
            <ac:spMk id="8" creationId="{08887007-58A9-4043-A9A2-D0CC96D1F9D6}"/>
          </ac:spMkLst>
        </pc:spChg>
        <pc:spChg chg="mod topLvl">
          <ac:chgData name="Sara Weis" userId="6a51f4e6-0e93-4a18-834c-a49e1ed77407" providerId="ADAL" clId="{6959E033-7E6A-4EA0-AB19-75F676599088}" dt="2025-01-02T17:18:41.401" v="421" actId="1076"/>
          <ac:spMkLst>
            <pc:docMk/>
            <pc:sldMk cId="1407140874" sldId="309"/>
            <ac:spMk id="20" creationId="{6881229C-7153-4EB2-8DAA-13FD4A567142}"/>
          </ac:spMkLst>
        </pc:spChg>
        <pc:spChg chg="mod topLvl">
          <ac:chgData name="Sara Weis" userId="6a51f4e6-0e93-4a18-834c-a49e1ed77407" providerId="ADAL" clId="{6959E033-7E6A-4EA0-AB19-75F676599088}" dt="2025-01-02T17:00:26.168" v="180" actId="164"/>
          <ac:spMkLst>
            <pc:docMk/>
            <pc:sldMk cId="1407140874" sldId="309"/>
            <ac:spMk id="25" creationId="{1739EE7F-4B26-492C-9A21-D8B4D53A95D3}"/>
          </ac:spMkLst>
        </pc:spChg>
        <pc:spChg chg="mod topLvl">
          <ac:chgData name="Sara Weis" userId="6a51f4e6-0e93-4a18-834c-a49e1ed77407" providerId="ADAL" clId="{6959E033-7E6A-4EA0-AB19-75F676599088}" dt="2025-01-02T17:00:26.168" v="180" actId="164"/>
          <ac:spMkLst>
            <pc:docMk/>
            <pc:sldMk cId="1407140874" sldId="309"/>
            <ac:spMk id="26" creationId="{9F8B62C0-0701-4452-9ECE-E70CF3460A27}"/>
          </ac:spMkLst>
        </pc:spChg>
        <pc:spChg chg="mod topLvl">
          <ac:chgData name="Sara Weis" userId="6a51f4e6-0e93-4a18-834c-a49e1ed77407" providerId="ADAL" clId="{6959E033-7E6A-4EA0-AB19-75F676599088}" dt="2025-01-02T17:18:41.401" v="421" actId="1076"/>
          <ac:spMkLst>
            <pc:docMk/>
            <pc:sldMk cId="1407140874" sldId="309"/>
            <ac:spMk id="27" creationId="{AFD89C10-828B-4348-9400-D3F10865C33A}"/>
          </ac:spMkLst>
        </pc:spChg>
        <pc:spChg chg="mod topLvl">
          <ac:chgData name="Sara Weis" userId="6a51f4e6-0e93-4a18-834c-a49e1ed77407" providerId="ADAL" clId="{6959E033-7E6A-4EA0-AB19-75F676599088}" dt="2025-01-02T17:18:41.401" v="421" actId="1076"/>
          <ac:spMkLst>
            <pc:docMk/>
            <pc:sldMk cId="1407140874" sldId="309"/>
            <ac:spMk id="29" creationId="{96BDDBF5-E0E9-4EDD-8442-02BF3C3A13F5}"/>
          </ac:spMkLst>
        </pc:spChg>
        <pc:spChg chg="mod topLvl">
          <ac:chgData name="Sara Weis" userId="6a51f4e6-0e93-4a18-834c-a49e1ed77407" providerId="ADAL" clId="{6959E033-7E6A-4EA0-AB19-75F676599088}" dt="2025-01-02T17:00:26.168" v="180" actId="164"/>
          <ac:spMkLst>
            <pc:docMk/>
            <pc:sldMk cId="1407140874" sldId="309"/>
            <ac:spMk id="31" creationId="{7D00C1B0-C791-429C-AD61-4475D35B2BB9}"/>
          </ac:spMkLst>
        </pc:spChg>
        <pc:spChg chg="mod topLvl">
          <ac:chgData name="Sara Weis" userId="6a51f4e6-0e93-4a18-834c-a49e1ed77407" providerId="ADAL" clId="{6959E033-7E6A-4EA0-AB19-75F676599088}" dt="2025-01-02T17:00:26.168" v="180" actId="164"/>
          <ac:spMkLst>
            <pc:docMk/>
            <pc:sldMk cId="1407140874" sldId="309"/>
            <ac:spMk id="32" creationId="{4B4C88B7-534D-4392-8B45-CD4DBD0E06DC}"/>
          </ac:spMkLst>
        </pc:spChg>
        <pc:spChg chg="add del mod">
          <ac:chgData name="Sara Weis" userId="6a51f4e6-0e93-4a18-834c-a49e1ed77407" providerId="ADAL" clId="{6959E033-7E6A-4EA0-AB19-75F676599088}" dt="2025-01-02T17:05:36.901" v="355" actId="478"/>
          <ac:spMkLst>
            <pc:docMk/>
            <pc:sldMk cId="1407140874" sldId="309"/>
            <ac:spMk id="36" creationId="{146899AB-8D1C-4F16-8820-601965BA1003}"/>
          </ac:spMkLst>
        </pc:spChg>
        <pc:spChg chg="mod topLvl">
          <ac:chgData name="Sara Weis" userId="6a51f4e6-0e93-4a18-834c-a49e1ed77407" providerId="ADAL" clId="{6959E033-7E6A-4EA0-AB19-75F676599088}" dt="2025-01-02T17:00:26.168" v="180" actId="164"/>
          <ac:spMkLst>
            <pc:docMk/>
            <pc:sldMk cId="1407140874" sldId="309"/>
            <ac:spMk id="62" creationId="{108CAF4E-2AB6-4B17-9E6F-F1E346041C65}"/>
          </ac:spMkLst>
        </pc:spChg>
        <pc:spChg chg="mod topLvl">
          <ac:chgData name="Sara Weis" userId="6a51f4e6-0e93-4a18-834c-a49e1ed77407" providerId="ADAL" clId="{6959E033-7E6A-4EA0-AB19-75F676599088}" dt="2025-01-02T17:00:26.168" v="180" actId="164"/>
          <ac:spMkLst>
            <pc:docMk/>
            <pc:sldMk cId="1407140874" sldId="309"/>
            <ac:spMk id="63" creationId="{511BFF64-48D6-483A-8213-539471607A7B}"/>
          </ac:spMkLst>
        </pc:spChg>
        <pc:spChg chg="mod topLvl">
          <ac:chgData name="Sara Weis" userId="6a51f4e6-0e93-4a18-834c-a49e1ed77407" providerId="ADAL" clId="{6959E033-7E6A-4EA0-AB19-75F676599088}" dt="2025-01-02T17:00:26.168" v="180" actId="164"/>
          <ac:spMkLst>
            <pc:docMk/>
            <pc:sldMk cId="1407140874" sldId="309"/>
            <ac:spMk id="66" creationId="{B972A8FF-4AEE-45F4-8801-82D1725996E7}"/>
          </ac:spMkLst>
        </pc:spChg>
        <pc:spChg chg="mod topLvl">
          <ac:chgData name="Sara Weis" userId="6a51f4e6-0e93-4a18-834c-a49e1ed77407" providerId="ADAL" clId="{6959E033-7E6A-4EA0-AB19-75F676599088}" dt="2025-01-02T17:00:26.168" v="180" actId="164"/>
          <ac:spMkLst>
            <pc:docMk/>
            <pc:sldMk cId="1407140874" sldId="309"/>
            <ac:spMk id="69" creationId="{7818342E-B8CF-47E2-93C2-646CD55FFAA5}"/>
          </ac:spMkLst>
        </pc:spChg>
        <pc:spChg chg="mod topLvl">
          <ac:chgData name="Sara Weis" userId="6a51f4e6-0e93-4a18-834c-a49e1ed77407" providerId="ADAL" clId="{6959E033-7E6A-4EA0-AB19-75F676599088}" dt="2025-01-02T17:00:26.168" v="180" actId="164"/>
          <ac:spMkLst>
            <pc:docMk/>
            <pc:sldMk cId="1407140874" sldId="309"/>
            <ac:spMk id="71" creationId="{BAD48846-1FF2-41CD-B750-B8CF8ED157F2}"/>
          </ac:spMkLst>
        </pc:spChg>
        <pc:spChg chg="mod topLvl">
          <ac:chgData name="Sara Weis" userId="6a51f4e6-0e93-4a18-834c-a49e1ed77407" providerId="ADAL" clId="{6959E033-7E6A-4EA0-AB19-75F676599088}" dt="2025-01-02T17:00:26.168" v="180" actId="164"/>
          <ac:spMkLst>
            <pc:docMk/>
            <pc:sldMk cId="1407140874" sldId="309"/>
            <ac:spMk id="72" creationId="{0B7EA0DE-D9AC-44F8-A250-58B0B4C4310A}"/>
          </ac:spMkLst>
        </pc:spChg>
        <pc:grpChg chg="add del mod">
          <ac:chgData name="Sara Weis" userId="6a51f4e6-0e93-4a18-834c-a49e1ed77407" providerId="ADAL" clId="{6959E033-7E6A-4EA0-AB19-75F676599088}" dt="2025-01-02T16:59:03.173" v="126" actId="165"/>
          <ac:grpSpMkLst>
            <pc:docMk/>
            <pc:sldMk cId="1407140874" sldId="309"/>
            <ac:grpSpMk id="2" creationId="{9BD144CA-C724-4B0F-B95A-C3F7FD4A5043}"/>
          </ac:grpSpMkLst>
        </pc:grpChg>
        <pc:grpChg chg="add mod">
          <ac:chgData name="Sara Weis" userId="6a51f4e6-0e93-4a18-834c-a49e1ed77407" providerId="ADAL" clId="{6959E033-7E6A-4EA0-AB19-75F676599088}" dt="2025-01-02T17:18:45.578" v="422" actId="1076"/>
          <ac:grpSpMkLst>
            <pc:docMk/>
            <pc:sldMk cId="1407140874" sldId="309"/>
            <ac:grpSpMk id="4" creationId="{EF7220AD-9458-4B13-9101-12BFA96A1810}"/>
          </ac:grpSpMkLst>
        </pc:grpChg>
        <pc:grpChg chg="mod topLvl">
          <ac:chgData name="Sara Weis" userId="6a51f4e6-0e93-4a18-834c-a49e1ed77407" providerId="ADAL" clId="{6959E033-7E6A-4EA0-AB19-75F676599088}" dt="2025-01-02T17:00:26.168" v="180" actId="164"/>
          <ac:grpSpMkLst>
            <pc:docMk/>
            <pc:sldMk cId="1407140874" sldId="309"/>
            <ac:grpSpMk id="35" creationId="{056DD648-E1CF-4B28-A93C-9EA63B3183AD}"/>
          </ac:grpSpMkLst>
        </pc:grpChg>
        <pc:grpChg chg="del mod topLvl">
          <ac:chgData name="Sara Weis" userId="6a51f4e6-0e93-4a18-834c-a49e1ed77407" providerId="ADAL" clId="{6959E033-7E6A-4EA0-AB19-75F676599088}" dt="2025-01-02T16:59:38.932" v="151" actId="165"/>
          <ac:grpSpMkLst>
            <pc:docMk/>
            <pc:sldMk cId="1407140874" sldId="309"/>
            <ac:grpSpMk id="77" creationId="{D67AE77C-DCA4-4EA9-BF3B-04475E2533A4}"/>
          </ac:grpSpMkLst>
        </pc:grpChg>
        <pc:picChg chg="mod topLvl">
          <ac:chgData name="Sara Weis" userId="6a51f4e6-0e93-4a18-834c-a49e1ed77407" providerId="ADAL" clId="{6959E033-7E6A-4EA0-AB19-75F676599088}" dt="2025-01-02T17:00:26.168" v="180" actId="164"/>
          <ac:picMkLst>
            <pc:docMk/>
            <pc:sldMk cId="1407140874" sldId="309"/>
            <ac:picMk id="19" creationId="{27EEF4B6-3B61-44D0-85D1-A7E062BA449C}"/>
          </ac:picMkLst>
        </pc:picChg>
        <pc:picChg chg="mod topLvl">
          <ac:chgData name="Sara Weis" userId="6a51f4e6-0e93-4a18-834c-a49e1ed77407" providerId="ADAL" clId="{6959E033-7E6A-4EA0-AB19-75F676599088}" dt="2025-01-02T17:00:26.168" v="180" actId="164"/>
          <ac:picMkLst>
            <pc:docMk/>
            <pc:sldMk cId="1407140874" sldId="309"/>
            <ac:picMk id="21" creationId="{FD23F2EB-CD30-4B78-8347-E59C22718A82}"/>
          </ac:picMkLst>
        </pc:picChg>
        <pc:picChg chg="mod topLvl">
          <ac:chgData name="Sara Weis" userId="6a51f4e6-0e93-4a18-834c-a49e1ed77407" providerId="ADAL" clId="{6959E033-7E6A-4EA0-AB19-75F676599088}" dt="2025-01-02T17:00:26.168" v="180" actId="164"/>
          <ac:picMkLst>
            <pc:docMk/>
            <pc:sldMk cId="1407140874" sldId="309"/>
            <ac:picMk id="45" creationId="{E5BF901F-73B1-4866-B87E-A2921145A5D4}"/>
          </ac:picMkLst>
        </pc:picChg>
        <pc:picChg chg="mod topLvl">
          <ac:chgData name="Sara Weis" userId="6a51f4e6-0e93-4a18-834c-a49e1ed77407" providerId="ADAL" clId="{6959E033-7E6A-4EA0-AB19-75F676599088}" dt="2025-01-02T17:00:26.168" v="180" actId="164"/>
          <ac:picMkLst>
            <pc:docMk/>
            <pc:sldMk cId="1407140874" sldId="309"/>
            <ac:picMk id="46" creationId="{D63FE4B1-4A92-4060-97D4-2DCCFD5A0A57}"/>
          </ac:picMkLst>
        </pc:picChg>
        <pc:picChg chg="mod topLvl">
          <ac:chgData name="Sara Weis" userId="6a51f4e6-0e93-4a18-834c-a49e1ed77407" providerId="ADAL" clId="{6959E033-7E6A-4EA0-AB19-75F676599088}" dt="2025-01-02T17:00:26.168" v="180" actId="164"/>
          <ac:picMkLst>
            <pc:docMk/>
            <pc:sldMk cId="1407140874" sldId="309"/>
            <ac:picMk id="47" creationId="{CC3F405E-00F9-49AE-834F-8D02BC0DEDDB}"/>
          </ac:picMkLst>
        </pc:picChg>
        <pc:picChg chg="mod topLvl">
          <ac:chgData name="Sara Weis" userId="6a51f4e6-0e93-4a18-834c-a49e1ed77407" providerId="ADAL" clId="{6959E033-7E6A-4EA0-AB19-75F676599088}" dt="2025-01-02T17:00:26.168" v="180" actId="164"/>
          <ac:picMkLst>
            <pc:docMk/>
            <pc:sldMk cId="1407140874" sldId="309"/>
            <ac:picMk id="49" creationId="{D6E85C12-BFDD-4BEA-AEA9-8FB8BDDFA099}"/>
          </ac:picMkLst>
        </pc:picChg>
        <pc:picChg chg="mod topLvl">
          <ac:chgData name="Sara Weis" userId="6a51f4e6-0e93-4a18-834c-a49e1ed77407" providerId="ADAL" clId="{6959E033-7E6A-4EA0-AB19-75F676599088}" dt="2025-01-02T17:00:26.168" v="180" actId="164"/>
          <ac:picMkLst>
            <pc:docMk/>
            <pc:sldMk cId="1407140874" sldId="309"/>
            <ac:picMk id="54" creationId="{96DAD91F-5FD9-4B38-8EA7-D2D986C34E88}"/>
          </ac:picMkLst>
        </pc:picChg>
        <pc:picChg chg="mod topLvl">
          <ac:chgData name="Sara Weis" userId="6a51f4e6-0e93-4a18-834c-a49e1ed77407" providerId="ADAL" clId="{6959E033-7E6A-4EA0-AB19-75F676599088}" dt="2025-01-02T17:00:26.168" v="180" actId="164"/>
          <ac:picMkLst>
            <pc:docMk/>
            <pc:sldMk cId="1407140874" sldId="309"/>
            <ac:picMk id="58" creationId="{3AD79D2C-BE67-4737-BD89-A0AB15F9DDF5}"/>
          </ac:picMkLst>
        </pc:picChg>
        <pc:cxnChg chg="mod topLvl">
          <ac:chgData name="Sara Weis" userId="6a51f4e6-0e93-4a18-834c-a49e1ed77407" providerId="ADAL" clId="{6959E033-7E6A-4EA0-AB19-75F676599088}" dt="2025-01-02T17:00:26.168" v="180" actId="164"/>
          <ac:cxnSpMkLst>
            <pc:docMk/>
            <pc:sldMk cId="1407140874" sldId="309"/>
            <ac:cxnSpMk id="61" creationId="{60770B83-1127-4F2D-B417-7730032C6158}"/>
          </ac:cxnSpMkLst>
        </pc:cxnChg>
        <pc:cxnChg chg="mod topLvl">
          <ac:chgData name="Sara Weis" userId="6a51f4e6-0e93-4a18-834c-a49e1ed77407" providerId="ADAL" clId="{6959E033-7E6A-4EA0-AB19-75F676599088}" dt="2025-01-02T17:00:26.168" v="180" actId="164"/>
          <ac:cxnSpMkLst>
            <pc:docMk/>
            <pc:sldMk cId="1407140874" sldId="309"/>
            <ac:cxnSpMk id="65" creationId="{36869760-8BC8-400F-9233-EDB338402EF1}"/>
          </ac:cxnSpMkLst>
        </pc:cxnChg>
        <pc:cxnChg chg="mod topLvl">
          <ac:chgData name="Sara Weis" userId="6a51f4e6-0e93-4a18-834c-a49e1ed77407" providerId="ADAL" clId="{6959E033-7E6A-4EA0-AB19-75F676599088}" dt="2025-01-02T17:00:26.168" v="180" actId="164"/>
          <ac:cxnSpMkLst>
            <pc:docMk/>
            <pc:sldMk cId="1407140874" sldId="309"/>
            <ac:cxnSpMk id="68" creationId="{8162CB15-C774-43CB-8E29-6C531374815F}"/>
          </ac:cxnSpMkLst>
        </pc:cxnChg>
      </pc:sldChg>
      <pc:sldChg chg="addSp delSp modSp">
        <pc:chgData name="Sara Weis" userId="6a51f4e6-0e93-4a18-834c-a49e1ed77407" providerId="ADAL" clId="{6959E033-7E6A-4EA0-AB19-75F676599088}" dt="2025-01-02T17:16:52.628" v="391" actId="1076"/>
        <pc:sldMkLst>
          <pc:docMk/>
          <pc:sldMk cId="2712744224" sldId="311"/>
        </pc:sldMkLst>
        <pc:spChg chg="add mod">
          <ac:chgData name="Sara Weis" userId="6a51f4e6-0e93-4a18-834c-a49e1ed77407" providerId="ADAL" clId="{6959E033-7E6A-4EA0-AB19-75F676599088}" dt="2025-01-02T17:16:49.358" v="390" actId="403"/>
          <ac:spMkLst>
            <pc:docMk/>
            <pc:sldMk cId="2712744224" sldId="311"/>
            <ac:spMk id="2" creationId="{8FEA17E4-D707-40D4-B8A6-05A0F86B4ED8}"/>
          </ac:spMkLst>
        </pc:spChg>
        <pc:spChg chg="del">
          <ac:chgData name="Sara Weis" userId="6a51f4e6-0e93-4a18-834c-a49e1ed77407" providerId="ADAL" clId="{6959E033-7E6A-4EA0-AB19-75F676599088}" dt="2025-01-02T17:04:36.070" v="335" actId="478"/>
          <ac:spMkLst>
            <pc:docMk/>
            <pc:sldMk cId="2712744224" sldId="311"/>
            <ac:spMk id="4" creationId="{EFF1A090-F7E6-4492-A0E2-DB77C11864EC}"/>
          </ac:spMkLst>
        </pc:spChg>
        <pc:spChg chg="del">
          <ac:chgData name="Sara Weis" userId="6a51f4e6-0e93-4a18-834c-a49e1ed77407" providerId="ADAL" clId="{6959E033-7E6A-4EA0-AB19-75F676599088}" dt="2025-01-02T17:04:05.317" v="293" actId="478"/>
          <ac:spMkLst>
            <pc:docMk/>
            <pc:sldMk cId="2712744224" sldId="311"/>
            <ac:spMk id="8" creationId="{176DA74B-212B-4CD8-AD83-20D4227BE0BE}"/>
          </ac:spMkLst>
        </pc:spChg>
        <pc:spChg chg="add del mod">
          <ac:chgData name="Sara Weis" userId="6a51f4e6-0e93-4a18-834c-a49e1ed77407" providerId="ADAL" clId="{6959E033-7E6A-4EA0-AB19-75F676599088}" dt="2025-01-02T17:04:53.166" v="342" actId="478"/>
          <ac:spMkLst>
            <pc:docMk/>
            <pc:sldMk cId="2712744224" sldId="311"/>
            <ac:spMk id="31" creationId="{C56981B2-F415-4A9E-A873-F7DE5E9788A4}"/>
          </ac:spMkLst>
        </pc:spChg>
        <pc:grpChg chg="del">
          <ac:chgData name="Sara Weis" userId="6a51f4e6-0e93-4a18-834c-a49e1ed77407" providerId="ADAL" clId="{6959E033-7E6A-4EA0-AB19-75F676599088}" dt="2025-01-02T17:04:05.317" v="293" actId="478"/>
          <ac:grpSpMkLst>
            <pc:docMk/>
            <pc:sldMk cId="2712744224" sldId="311"/>
            <ac:grpSpMk id="17" creationId="{3AD46ADA-27C5-4509-BC5D-8E2838B8B03B}"/>
          </ac:grpSpMkLst>
        </pc:grpChg>
        <pc:grpChg chg="del">
          <ac:chgData name="Sara Weis" userId="6a51f4e6-0e93-4a18-834c-a49e1ed77407" providerId="ADAL" clId="{6959E033-7E6A-4EA0-AB19-75F676599088}" dt="2025-01-02T17:04:05.317" v="293" actId="478"/>
          <ac:grpSpMkLst>
            <pc:docMk/>
            <pc:sldMk cId="2712744224" sldId="311"/>
            <ac:grpSpMk id="32" creationId="{AEFCE027-3D20-461D-B064-12E9E1F01B51}"/>
          </ac:grpSpMkLst>
        </pc:grpChg>
        <pc:graphicFrameChg chg="del">
          <ac:chgData name="Sara Weis" userId="6a51f4e6-0e93-4a18-834c-a49e1ed77407" providerId="ADAL" clId="{6959E033-7E6A-4EA0-AB19-75F676599088}" dt="2025-01-02T17:04:05.317" v="293" actId="478"/>
          <ac:graphicFrameMkLst>
            <pc:docMk/>
            <pc:sldMk cId="2712744224" sldId="311"/>
            <ac:graphicFrameMk id="66" creationId="{111A6526-7355-44C6-8032-64EE94B50FD5}"/>
          </ac:graphicFrameMkLst>
        </pc:graphicFrameChg>
        <pc:picChg chg="mod">
          <ac:chgData name="Sara Weis" userId="6a51f4e6-0e93-4a18-834c-a49e1ed77407" providerId="ADAL" clId="{6959E033-7E6A-4EA0-AB19-75F676599088}" dt="2025-01-02T17:16:52.628" v="391" actId="1076"/>
          <ac:picMkLst>
            <pc:docMk/>
            <pc:sldMk cId="2712744224" sldId="311"/>
            <ac:picMk id="7" creationId="{1351158B-83E9-448C-978B-1EA485DEA316}"/>
          </ac:picMkLst>
        </pc:picChg>
        <pc:cxnChg chg="del">
          <ac:chgData name="Sara Weis" userId="6a51f4e6-0e93-4a18-834c-a49e1ed77407" providerId="ADAL" clId="{6959E033-7E6A-4EA0-AB19-75F676599088}" dt="2025-01-02T17:04:05.317" v="293" actId="478"/>
          <ac:cxnSpMkLst>
            <pc:docMk/>
            <pc:sldMk cId="2712744224" sldId="311"/>
            <ac:cxnSpMk id="67" creationId="{900452E5-2F38-400C-871D-592F39BB8149}"/>
          </ac:cxnSpMkLst>
        </pc:cxnChg>
      </pc:sldChg>
      <pc:sldChg chg="addSp delSp modSp add">
        <pc:chgData name="Sara Weis" userId="6a51f4e6-0e93-4a18-834c-a49e1ed77407" providerId="ADAL" clId="{6959E033-7E6A-4EA0-AB19-75F676599088}" dt="2025-01-02T17:17:59.407" v="418" actId="20577"/>
        <pc:sldMkLst>
          <pc:docMk/>
          <pc:sldMk cId="2356307124" sldId="312"/>
        </pc:sldMkLst>
        <pc:spChg chg="add mod">
          <ac:chgData name="Sara Weis" userId="6a51f4e6-0e93-4a18-834c-a49e1ed77407" providerId="ADAL" clId="{6959E033-7E6A-4EA0-AB19-75F676599088}" dt="2025-01-02T17:17:59.407" v="418" actId="20577"/>
          <ac:spMkLst>
            <pc:docMk/>
            <pc:sldMk cId="2356307124" sldId="312"/>
            <ac:spMk id="2" creationId="{4D9D5902-05D5-4827-AE64-44E64AA62EA2}"/>
          </ac:spMkLst>
        </pc:spChg>
        <pc:spChg chg="del">
          <ac:chgData name="Sara Weis" userId="6a51f4e6-0e93-4a18-834c-a49e1ed77407" providerId="ADAL" clId="{6959E033-7E6A-4EA0-AB19-75F676599088}" dt="2025-01-02T17:02:44.579" v="235" actId="478"/>
          <ac:spMkLst>
            <pc:docMk/>
            <pc:sldMk cId="2356307124" sldId="312"/>
            <ac:spMk id="4" creationId="{EFF1A090-F7E6-4492-A0E2-DB77C11864EC}"/>
          </ac:spMkLst>
        </pc:spChg>
        <pc:spChg chg="del">
          <ac:chgData name="Sara Weis" userId="6a51f4e6-0e93-4a18-834c-a49e1ed77407" providerId="ADAL" clId="{6959E033-7E6A-4EA0-AB19-75F676599088}" dt="2025-01-02T17:02:49.963" v="238" actId="478"/>
          <ac:spMkLst>
            <pc:docMk/>
            <pc:sldMk cId="2356307124" sldId="312"/>
            <ac:spMk id="8" creationId="{176DA74B-212B-4CD8-AD83-20D4227BE0BE}"/>
          </ac:spMkLst>
        </pc:spChg>
        <pc:spChg chg="del mod">
          <ac:chgData name="Sara Weis" userId="6a51f4e6-0e93-4a18-834c-a49e1ed77407" providerId="ADAL" clId="{6959E033-7E6A-4EA0-AB19-75F676599088}" dt="2025-01-02T17:04:58.125" v="343" actId="478"/>
          <ac:spMkLst>
            <pc:docMk/>
            <pc:sldMk cId="2356307124" sldId="312"/>
            <ac:spMk id="31" creationId="{C56981B2-F415-4A9E-A873-F7DE5E9788A4}"/>
          </ac:spMkLst>
        </pc:spChg>
        <pc:spChg chg="mod">
          <ac:chgData name="Sara Weis" userId="6a51f4e6-0e93-4a18-834c-a49e1ed77407" providerId="ADAL" clId="{6959E033-7E6A-4EA0-AB19-75F676599088}" dt="2025-01-02T17:17:16.576" v="404" actId="404"/>
          <ac:spMkLst>
            <pc:docMk/>
            <pc:sldMk cId="2356307124" sldId="312"/>
            <ac:spMk id="34" creationId="{7245DFBF-E367-42CE-9BC0-1CC284935543}"/>
          </ac:spMkLst>
        </pc:spChg>
        <pc:spChg chg="mod">
          <ac:chgData name="Sara Weis" userId="6a51f4e6-0e93-4a18-834c-a49e1ed77407" providerId="ADAL" clId="{6959E033-7E6A-4EA0-AB19-75F676599088}" dt="2025-01-02T17:17:20.827" v="405" actId="1076"/>
          <ac:spMkLst>
            <pc:docMk/>
            <pc:sldMk cId="2356307124" sldId="312"/>
            <ac:spMk id="35" creationId="{FF84D828-1683-4212-9A04-530622F68783}"/>
          </ac:spMkLst>
        </pc:spChg>
        <pc:spChg chg="mod">
          <ac:chgData name="Sara Weis" userId="6a51f4e6-0e93-4a18-834c-a49e1ed77407" providerId="ADAL" clId="{6959E033-7E6A-4EA0-AB19-75F676599088}" dt="2025-01-02T17:17:24.806" v="407" actId="14100"/>
          <ac:spMkLst>
            <pc:docMk/>
            <pc:sldMk cId="2356307124" sldId="312"/>
            <ac:spMk id="36" creationId="{1FC9477D-6E24-442C-9FA5-58E70ABD35D1}"/>
          </ac:spMkLst>
        </pc:spChg>
        <pc:spChg chg="mod">
          <ac:chgData name="Sara Weis" userId="6a51f4e6-0e93-4a18-834c-a49e1ed77407" providerId="ADAL" clId="{6959E033-7E6A-4EA0-AB19-75F676599088}" dt="2025-01-02T17:17:27.382" v="408" actId="1076"/>
          <ac:spMkLst>
            <pc:docMk/>
            <pc:sldMk cId="2356307124" sldId="312"/>
            <ac:spMk id="37" creationId="{77012511-9E81-45CF-B84C-A520A6C63417}"/>
          </ac:spMkLst>
        </pc:spChg>
        <pc:spChg chg="mod">
          <ac:chgData name="Sara Weis" userId="6a51f4e6-0e93-4a18-834c-a49e1ed77407" providerId="ADAL" clId="{6959E033-7E6A-4EA0-AB19-75F676599088}" dt="2025-01-02T17:17:16.576" v="404" actId="404"/>
          <ac:spMkLst>
            <pc:docMk/>
            <pc:sldMk cId="2356307124" sldId="312"/>
            <ac:spMk id="38" creationId="{3DB68739-9E51-4261-B67F-EEB63C4BA948}"/>
          </ac:spMkLst>
        </pc:spChg>
        <pc:spChg chg="mod">
          <ac:chgData name="Sara Weis" userId="6a51f4e6-0e93-4a18-834c-a49e1ed77407" providerId="ADAL" clId="{6959E033-7E6A-4EA0-AB19-75F676599088}" dt="2025-01-02T17:17:16.576" v="404" actId="404"/>
          <ac:spMkLst>
            <pc:docMk/>
            <pc:sldMk cId="2356307124" sldId="312"/>
            <ac:spMk id="39" creationId="{B5400EC5-E183-4B29-A883-E4711603516E}"/>
          </ac:spMkLst>
        </pc:spChg>
        <pc:grpChg chg="add del mod">
          <ac:chgData name="Sara Weis" userId="6a51f4e6-0e93-4a18-834c-a49e1ed77407" providerId="ADAL" clId="{6959E033-7E6A-4EA0-AB19-75F676599088}" dt="2025-01-02T17:17:10.519" v="396" actId="165"/>
          <ac:grpSpMkLst>
            <pc:docMk/>
            <pc:sldMk cId="2356307124" sldId="312"/>
            <ac:grpSpMk id="5" creationId="{F0736E05-44C9-4E0F-B450-06399BD2E38F}"/>
          </ac:grpSpMkLst>
        </pc:grpChg>
        <pc:grpChg chg="mod topLvl">
          <ac:chgData name="Sara Weis" userId="6a51f4e6-0e93-4a18-834c-a49e1ed77407" providerId="ADAL" clId="{6959E033-7E6A-4EA0-AB19-75F676599088}" dt="2025-01-02T17:17:52.766" v="415" actId="1076"/>
          <ac:grpSpMkLst>
            <pc:docMk/>
            <pc:sldMk cId="2356307124" sldId="312"/>
            <ac:grpSpMk id="17" creationId="{3AD46ADA-27C5-4509-BC5D-8E2838B8B03B}"/>
          </ac:grpSpMkLst>
        </pc:grpChg>
        <pc:grpChg chg="mod topLvl">
          <ac:chgData name="Sara Weis" userId="6a51f4e6-0e93-4a18-834c-a49e1ed77407" providerId="ADAL" clId="{6959E033-7E6A-4EA0-AB19-75F676599088}" dt="2025-01-02T17:17:52.766" v="415" actId="1076"/>
          <ac:grpSpMkLst>
            <pc:docMk/>
            <pc:sldMk cId="2356307124" sldId="312"/>
            <ac:grpSpMk id="32" creationId="{AEFCE027-3D20-461D-B064-12E9E1F01B51}"/>
          </ac:grpSpMkLst>
        </pc:grpChg>
        <pc:grpChg chg="mod">
          <ac:chgData name="Sara Weis" userId="6a51f4e6-0e93-4a18-834c-a49e1ed77407" providerId="ADAL" clId="{6959E033-7E6A-4EA0-AB19-75F676599088}" dt="2025-01-02T17:17:52.766" v="415" actId="1076"/>
          <ac:grpSpMkLst>
            <pc:docMk/>
            <pc:sldMk cId="2356307124" sldId="312"/>
            <ac:grpSpMk id="33" creationId="{2ED8BAA9-40D7-40CC-906F-F42E40F72D84}"/>
          </ac:grpSpMkLst>
        </pc:grpChg>
        <pc:graphicFrameChg chg="mod topLvl">
          <ac:chgData name="Sara Weis" userId="6a51f4e6-0e93-4a18-834c-a49e1ed77407" providerId="ADAL" clId="{6959E033-7E6A-4EA0-AB19-75F676599088}" dt="2025-01-02T17:17:52.766" v="415" actId="1076"/>
          <ac:graphicFrameMkLst>
            <pc:docMk/>
            <pc:sldMk cId="2356307124" sldId="312"/>
            <ac:graphicFrameMk id="66" creationId="{111A6526-7355-44C6-8032-64EE94B50FD5}"/>
          </ac:graphicFrameMkLst>
        </pc:graphicFrameChg>
        <pc:picChg chg="mod">
          <ac:chgData name="Sara Weis" userId="6a51f4e6-0e93-4a18-834c-a49e1ed77407" providerId="ADAL" clId="{6959E033-7E6A-4EA0-AB19-75F676599088}" dt="2025-01-02T17:05:17.936" v="349" actId="1076"/>
          <ac:picMkLst>
            <pc:docMk/>
            <pc:sldMk cId="2356307124" sldId="312"/>
            <ac:picMk id="3" creationId="{A6327666-5840-B3BB-17A2-7B4D54247304}"/>
          </ac:picMkLst>
        </pc:picChg>
        <pc:picChg chg="del">
          <ac:chgData name="Sara Weis" userId="6a51f4e6-0e93-4a18-834c-a49e1ed77407" providerId="ADAL" clId="{6959E033-7E6A-4EA0-AB19-75F676599088}" dt="2025-01-02T17:02:44.579" v="235" actId="478"/>
          <ac:picMkLst>
            <pc:docMk/>
            <pc:sldMk cId="2356307124" sldId="312"/>
            <ac:picMk id="7" creationId="{1351158B-83E9-448C-978B-1EA485DEA316}"/>
          </ac:picMkLst>
        </pc:picChg>
        <pc:cxnChg chg="mod topLvl">
          <ac:chgData name="Sara Weis" userId="6a51f4e6-0e93-4a18-834c-a49e1ed77407" providerId="ADAL" clId="{6959E033-7E6A-4EA0-AB19-75F676599088}" dt="2025-01-02T17:17:52.766" v="415" actId="1076"/>
          <ac:cxnSpMkLst>
            <pc:docMk/>
            <pc:sldMk cId="2356307124" sldId="312"/>
            <ac:cxnSpMk id="67" creationId="{900452E5-2F38-400C-871D-592F39BB8149}"/>
          </ac:cxnSpMkLst>
        </pc:cxnChg>
      </pc:sldChg>
    </pc:docChg>
  </pc:docChgLst>
  <pc:docChgLst>
    <pc:chgData name="Sara Weis" userId="6a51f4e6-0e93-4a18-834c-a49e1ed77407" providerId="ADAL" clId="{E55452D4-D8AD-4C9F-8C71-A93621736ECA}"/>
    <pc:docChg chg="delSld">
      <pc:chgData name="Sara Weis" userId="6a51f4e6-0e93-4a18-834c-a49e1ed77407" providerId="ADAL" clId="{E55452D4-D8AD-4C9F-8C71-A93621736ECA}" dt="2025-01-02T17:22:56.769" v="2" actId="2696"/>
      <pc:docMkLst>
        <pc:docMk/>
      </pc:docMkLst>
      <pc:sldChg chg="del">
        <pc:chgData name="Sara Weis" userId="6a51f4e6-0e93-4a18-834c-a49e1ed77407" providerId="ADAL" clId="{E55452D4-D8AD-4C9F-8C71-A93621736ECA}" dt="2025-01-02T17:22:56.769" v="2" actId="2696"/>
        <pc:sldMkLst>
          <pc:docMk/>
          <pc:sldMk cId="2106248321" sldId="298"/>
        </pc:sldMkLst>
      </pc:sldChg>
      <pc:sldChg chg="del">
        <pc:chgData name="Sara Weis" userId="6a51f4e6-0e93-4a18-834c-a49e1ed77407" providerId="ADAL" clId="{E55452D4-D8AD-4C9F-8C71-A93621736ECA}" dt="2025-01-02T17:22:56.768" v="1" actId="2696"/>
        <pc:sldMkLst>
          <pc:docMk/>
          <pc:sldMk cId="2712744224" sldId="311"/>
        </pc:sldMkLst>
      </pc:sldChg>
      <pc:sldChg chg="del">
        <pc:chgData name="Sara Weis" userId="6a51f4e6-0e93-4a18-834c-a49e1ed77407" providerId="ADAL" clId="{E55452D4-D8AD-4C9F-8C71-A93621736ECA}" dt="2025-01-02T17:22:56.759" v="0" actId="2696"/>
        <pc:sldMkLst>
          <pc:docMk/>
          <pc:sldMk cId="2356307124" sldId="312"/>
        </pc:sldMkLst>
      </pc:sldChg>
    </pc:docChg>
  </pc:docChgLst>
  <pc:docChgLst>
    <pc:chgData name="Sara Weis" userId="6a51f4e6-0e93-4a18-834c-a49e1ed77407" providerId="ADAL" clId="{5B9D748F-4140-4F29-A6FB-884F3F5921E6}"/>
    <pc:docChg chg="delSld modSld">
      <pc:chgData name="Sara Weis" userId="6a51f4e6-0e93-4a18-834c-a49e1ed77407" providerId="ADAL" clId="{5B9D748F-4140-4F29-A6FB-884F3F5921E6}" dt="2025-01-02T16:47:04.763" v="12" actId="20577"/>
      <pc:docMkLst>
        <pc:docMk/>
      </pc:docMkLst>
      <pc:sldChg chg="modSp">
        <pc:chgData name="Sara Weis" userId="6a51f4e6-0e93-4a18-834c-a49e1ed77407" providerId="ADAL" clId="{5B9D748F-4140-4F29-A6FB-884F3F5921E6}" dt="2025-01-02T16:46:55.225" v="6" actId="20577"/>
        <pc:sldMkLst>
          <pc:docMk/>
          <pc:sldMk cId="2106248321" sldId="298"/>
        </pc:sldMkLst>
        <pc:spChg chg="mod">
          <ac:chgData name="Sara Weis" userId="6a51f4e6-0e93-4a18-834c-a49e1ed77407" providerId="ADAL" clId="{5B9D748F-4140-4F29-A6FB-884F3F5921E6}" dt="2025-01-02T16:46:52.776" v="4" actId="20577"/>
          <ac:spMkLst>
            <pc:docMk/>
            <pc:sldMk cId="2106248321" sldId="298"/>
            <ac:spMk id="23" creationId="{9837469B-6902-495A-86E3-722D7C6A57DC}"/>
          </ac:spMkLst>
        </pc:spChg>
        <pc:spChg chg="mod">
          <ac:chgData name="Sara Weis" userId="6a51f4e6-0e93-4a18-834c-a49e1ed77407" providerId="ADAL" clId="{5B9D748F-4140-4F29-A6FB-884F3F5921E6}" dt="2025-01-02T16:46:48.408" v="2" actId="20577"/>
          <ac:spMkLst>
            <pc:docMk/>
            <pc:sldMk cId="2106248321" sldId="298"/>
            <ac:spMk id="45" creationId="{F3A9156C-C54C-4614-ABB9-5AF095F0F775}"/>
          </ac:spMkLst>
        </pc:spChg>
        <pc:spChg chg="mod">
          <ac:chgData name="Sara Weis" userId="6a51f4e6-0e93-4a18-834c-a49e1ed77407" providerId="ADAL" clId="{5B9D748F-4140-4F29-A6FB-884F3F5921E6}" dt="2025-01-02T16:46:55.225" v="6" actId="20577"/>
          <ac:spMkLst>
            <pc:docMk/>
            <pc:sldMk cId="2106248321" sldId="298"/>
            <ac:spMk id="70" creationId="{7A30D47F-4FE9-4840-9977-6022DD4A371A}"/>
          </ac:spMkLst>
        </pc:spChg>
      </pc:sldChg>
      <pc:sldChg chg="del">
        <pc:chgData name="Sara Weis" userId="6a51f4e6-0e93-4a18-834c-a49e1ed77407" providerId="ADAL" clId="{5B9D748F-4140-4F29-A6FB-884F3F5921E6}" dt="2025-01-02T16:46:43.245" v="0" actId="2696"/>
        <pc:sldMkLst>
          <pc:docMk/>
          <pc:sldMk cId="3697787146" sldId="301"/>
        </pc:sldMkLst>
      </pc:sldChg>
      <pc:sldChg chg="modSp">
        <pc:chgData name="Sara Weis" userId="6a51f4e6-0e93-4a18-834c-a49e1ed77407" providerId="ADAL" clId="{5B9D748F-4140-4F29-A6FB-884F3F5921E6}" dt="2025-01-02T16:46:58.680" v="8" actId="20577"/>
        <pc:sldMkLst>
          <pc:docMk/>
          <pc:sldMk cId="1407140874" sldId="309"/>
        </pc:sldMkLst>
        <pc:spChg chg="mod">
          <ac:chgData name="Sara Weis" userId="6a51f4e6-0e93-4a18-834c-a49e1ed77407" providerId="ADAL" clId="{5B9D748F-4140-4F29-A6FB-884F3F5921E6}" dt="2025-01-02T16:46:58.680" v="8" actId="20577"/>
          <ac:spMkLst>
            <pc:docMk/>
            <pc:sldMk cId="1407140874" sldId="309"/>
            <ac:spMk id="5" creationId="{B847A6B5-FE3F-456F-A592-96E2D8DDCCD8}"/>
          </ac:spMkLst>
        </pc:spChg>
      </pc:sldChg>
      <pc:sldChg chg="modSp">
        <pc:chgData name="Sara Weis" userId="6a51f4e6-0e93-4a18-834c-a49e1ed77407" providerId="ADAL" clId="{5B9D748F-4140-4F29-A6FB-884F3F5921E6}" dt="2025-01-02T16:47:04.763" v="12" actId="20577"/>
        <pc:sldMkLst>
          <pc:docMk/>
          <pc:sldMk cId="2712744224" sldId="311"/>
        </pc:sldMkLst>
        <pc:spChg chg="mod">
          <ac:chgData name="Sara Weis" userId="6a51f4e6-0e93-4a18-834c-a49e1ed77407" providerId="ADAL" clId="{5B9D748F-4140-4F29-A6FB-884F3F5921E6}" dt="2025-01-02T16:47:02.568" v="10" actId="20577"/>
          <ac:spMkLst>
            <pc:docMk/>
            <pc:sldMk cId="2712744224" sldId="311"/>
            <ac:spMk id="4" creationId="{EFF1A090-F7E6-4492-A0E2-DB77C11864EC}"/>
          </ac:spMkLst>
        </pc:spChg>
        <pc:spChg chg="mod">
          <ac:chgData name="Sara Weis" userId="6a51f4e6-0e93-4a18-834c-a49e1ed77407" providerId="ADAL" clId="{5B9D748F-4140-4F29-A6FB-884F3F5921E6}" dt="2025-01-02T16:47:04.763" v="12" actId="20577"/>
          <ac:spMkLst>
            <pc:docMk/>
            <pc:sldMk cId="2712744224" sldId="311"/>
            <ac:spMk id="8" creationId="{176DA74B-212B-4CD8-AD83-20D4227BE0BE}"/>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920" cy="481727"/>
          </a:xfrm>
          <a:prstGeom prst="rect">
            <a:avLst/>
          </a:prstGeom>
        </p:spPr>
        <p:txBody>
          <a:bodyPr vert="horz" lIns="96661" tIns="48331" rIns="96661" bIns="48331" rtlCol="0"/>
          <a:lstStyle>
            <a:lvl1pPr algn="l">
              <a:defRPr sz="1300"/>
            </a:lvl1pPr>
          </a:lstStyle>
          <a:p>
            <a:endParaRPr lang="en-US"/>
          </a:p>
        </p:txBody>
      </p:sp>
      <p:sp>
        <p:nvSpPr>
          <p:cNvPr id="3" name="Date Placeholder 2"/>
          <p:cNvSpPr>
            <a:spLocks noGrp="1"/>
          </p:cNvSpPr>
          <p:nvPr>
            <p:ph type="dt" idx="1"/>
          </p:nvPr>
        </p:nvSpPr>
        <p:spPr>
          <a:xfrm>
            <a:off x="4143587" y="0"/>
            <a:ext cx="3169920" cy="481727"/>
          </a:xfrm>
          <a:prstGeom prst="rect">
            <a:avLst/>
          </a:prstGeom>
        </p:spPr>
        <p:txBody>
          <a:bodyPr vert="horz" lIns="96661" tIns="48331" rIns="96661" bIns="48331" rtlCol="0"/>
          <a:lstStyle>
            <a:lvl1pPr algn="r">
              <a:defRPr sz="1300"/>
            </a:lvl1pPr>
          </a:lstStyle>
          <a:p>
            <a:fld id="{8556F641-4CF0-450A-AF50-26BA00F47CDE}" type="datetimeFigureOut">
              <a:rPr lang="en-US" smtClean="0"/>
              <a:t>1/2/2025</a:t>
            </a:fld>
            <a:endParaRPr lang="en-US"/>
          </a:p>
        </p:txBody>
      </p:sp>
      <p:sp>
        <p:nvSpPr>
          <p:cNvPr id="4" name="Slide Image Placeholder 3"/>
          <p:cNvSpPr>
            <a:spLocks noGrp="1" noRot="1" noChangeAspect="1"/>
          </p:cNvSpPr>
          <p:nvPr>
            <p:ph type="sldImg" idx="2"/>
          </p:nvPr>
        </p:nvSpPr>
        <p:spPr>
          <a:xfrm>
            <a:off x="2535238" y="1200150"/>
            <a:ext cx="2244725" cy="3240088"/>
          </a:xfrm>
          <a:prstGeom prst="rect">
            <a:avLst/>
          </a:prstGeom>
          <a:noFill/>
          <a:ln w="12700">
            <a:solidFill>
              <a:prstClr val="black"/>
            </a:solidFill>
          </a:ln>
        </p:spPr>
        <p:txBody>
          <a:bodyPr vert="horz" lIns="96661" tIns="48331" rIns="96661" bIns="48331" rtlCol="0" anchor="ctr"/>
          <a:lstStyle/>
          <a:p>
            <a:endParaRPr lang="en-US"/>
          </a:p>
        </p:txBody>
      </p:sp>
      <p:sp>
        <p:nvSpPr>
          <p:cNvPr id="5" name="Notes Placeholder 4"/>
          <p:cNvSpPr>
            <a:spLocks noGrp="1"/>
          </p:cNvSpPr>
          <p:nvPr>
            <p:ph type="body" sz="quarter" idx="3"/>
          </p:nvPr>
        </p:nvSpPr>
        <p:spPr>
          <a:xfrm>
            <a:off x="731520" y="4620577"/>
            <a:ext cx="5852160" cy="3780473"/>
          </a:xfrm>
          <a:prstGeom prst="rect">
            <a:avLst/>
          </a:prstGeom>
        </p:spPr>
        <p:txBody>
          <a:bodyPr vert="horz" lIns="96661" tIns="48331" rIns="96661" bIns="48331"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119474"/>
            <a:ext cx="3169920" cy="481726"/>
          </a:xfrm>
          <a:prstGeom prst="rect">
            <a:avLst/>
          </a:prstGeom>
        </p:spPr>
        <p:txBody>
          <a:bodyPr vert="horz" lIns="96661" tIns="48331" rIns="96661" bIns="48331" rtlCol="0" anchor="b"/>
          <a:lstStyle>
            <a:lvl1pPr algn="l">
              <a:defRPr sz="1300"/>
            </a:lvl1pPr>
          </a:lstStyle>
          <a:p>
            <a:endParaRPr lang="en-US"/>
          </a:p>
        </p:txBody>
      </p:sp>
      <p:sp>
        <p:nvSpPr>
          <p:cNvPr id="7" name="Slide Number Placeholder 6"/>
          <p:cNvSpPr>
            <a:spLocks noGrp="1"/>
          </p:cNvSpPr>
          <p:nvPr>
            <p:ph type="sldNum" sz="quarter" idx="5"/>
          </p:nvPr>
        </p:nvSpPr>
        <p:spPr>
          <a:xfrm>
            <a:off x="4143587" y="9119474"/>
            <a:ext cx="3169920" cy="481726"/>
          </a:xfrm>
          <a:prstGeom prst="rect">
            <a:avLst/>
          </a:prstGeom>
        </p:spPr>
        <p:txBody>
          <a:bodyPr vert="horz" lIns="96661" tIns="48331" rIns="96661" bIns="48331" rtlCol="0" anchor="b"/>
          <a:lstStyle>
            <a:lvl1pPr algn="r">
              <a:defRPr sz="1300"/>
            </a:lvl1pPr>
          </a:lstStyle>
          <a:p>
            <a:fld id="{306F44C2-743C-4165-B45D-193A312A7D28}" type="slidenum">
              <a:rPr lang="en-US" smtClean="0"/>
              <a:t>‹#›</a:t>
            </a:fld>
            <a:endParaRPr lang="en-US"/>
          </a:p>
        </p:txBody>
      </p:sp>
    </p:spTree>
    <p:extLst>
      <p:ext uri="{BB962C8B-B14F-4D97-AF65-F5344CB8AC3E}">
        <p14:creationId xmlns:p14="http://schemas.microsoft.com/office/powerpoint/2010/main" val="14557285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306F44C2-743C-4165-B45D-193A312A7D28}" type="slidenum">
              <a:rPr lang="en-US" smtClean="0"/>
              <a:t>1</a:t>
            </a:fld>
            <a:endParaRPr lang="en-US"/>
          </a:p>
        </p:txBody>
      </p:sp>
    </p:spTree>
    <p:extLst>
      <p:ext uri="{BB962C8B-B14F-4D97-AF65-F5344CB8AC3E}">
        <p14:creationId xmlns:p14="http://schemas.microsoft.com/office/powerpoint/2010/main" val="40091133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C1B7451F-75FE-468E-B432-185B2D62D082}" type="datetimeFigureOut">
              <a:rPr lang="en-US" smtClean="0"/>
              <a:t>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34332504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1B7451F-75FE-468E-B432-185B2D62D082}" type="datetimeFigureOut">
              <a:rPr lang="en-US" smtClean="0"/>
              <a:t>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25877690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1B7451F-75FE-468E-B432-185B2D62D082}" type="datetimeFigureOut">
              <a:rPr lang="en-US" smtClean="0"/>
              <a:t>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16193299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1B7451F-75FE-468E-B432-185B2D62D082}" type="datetimeFigureOut">
              <a:rPr lang="en-US" smtClean="0"/>
              <a:t>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23322919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1B7451F-75FE-468E-B432-185B2D62D082}" type="datetimeFigureOut">
              <a:rPr lang="en-US" smtClean="0"/>
              <a:t>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27735701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1B7451F-75FE-468E-B432-185B2D62D082}" type="datetimeFigureOut">
              <a:rPr lang="en-US" smtClean="0"/>
              <a:t>1/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915906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1B7451F-75FE-468E-B432-185B2D62D082}" type="datetimeFigureOut">
              <a:rPr lang="en-US" smtClean="0"/>
              <a:t>1/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5157310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1B7451F-75FE-468E-B432-185B2D62D082}" type="datetimeFigureOut">
              <a:rPr lang="en-US" smtClean="0"/>
              <a:t>1/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437151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1B7451F-75FE-468E-B432-185B2D62D082}" type="datetimeFigureOut">
              <a:rPr lang="en-US" smtClean="0"/>
              <a:t>1/2/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3699967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1B7451F-75FE-468E-B432-185B2D62D082}" type="datetimeFigureOut">
              <a:rPr lang="en-US" smtClean="0"/>
              <a:t>1/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413903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1B7451F-75FE-468E-B432-185B2D62D082}" type="datetimeFigureOut">
              <a:rPr lang="en-US" smtClean="0"/>
              <a:t>1/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54D952-7280-4B8F-A320-F189AA12094A}" type="slidenum">
              <a:rPr lang="en-US" smtClean="0"/>
              <a:t>‹#›</a:t>
            </a:fld>
            <a:endParaRPr lang="en-US"/>
          </a:p>
        </p:txBody>
      </p:sp>
    </p:spTree>
    <p:extLst>
      <p:ext uri="{BB962C8B-B14F-4D97-AF65-F5344CB8AC3E}">
        <p14:creationId xmlns:p14="http://schemas.microsoft.com/office/powerpoint/2010/main" val="7068218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C1B7451F-75FE-468E-B432-185B2D62D082}" type="datetimeFigureOut">
              <a:rPr lang="en-US" smtClean="0"/>
              <a:t>1/2/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4D54D952-7280-4B8F-A320-F189AA12094A}" type="slidenum">
              <a:rPr lang="en-US" smtClean="0"/>
              <a:t>‹#›</a:t>
            </a:fld>
            <a:endParaRPr lang="en-US"/>
          </a:p>
        </p:txBody>
      </p:sp>
    </p:spTree>
    <p:extLst>
      <p:ext uri="{BB962C8B-B14F-4D97-AF65-F5344CB8AC3E}">
        <p14:creationId xmlns:p14="http://schemas.microsoft.com/office/powerpoint/2010/main" val="197920409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13" Type="http://schemas.openxmlformats.org/officeDocument/2006/relationships/image" Target="../media/image8.png"/><Relationship Id="rId18" Type="http://schemas.microsoft.com/office/2007/relationships/hdphoto" Target="../media/hdphoto6.wdp"/><Relationship Id="rId3" Type="http://schemas.openxmlformats.org/officeDocument/2006/relationships/image" Target="../media/image1.tiff"/><Relationship Id="rId7" Type="http://schemas.microsoft.com/office/2007/relationships/hdphoto" Target="../media/hdphoto1.wdp"/><Relationship Id="rId12" Type="http://schemas.microsoft.com/office/2007/relationships/hdphoto" Target="../media/hdphoto3.wdp"/><Relationship Id="rId17" Type="http://schemas.openxmlformats.org/officeDocument/2006/relationships/image" Target="../media/image10.png"/><Relationship Id="rId2" Type="http://schemas.openxmlformats.org/officeDocument/2006/relationships/notesSlide" Target="../notesSlides/notesSlide1.xml"/><Relationship Id="rId16" Type="http://schemas.microsoft.com/office/2007/relationships/hdphoto" Target="../media/hdphoto5.wdp"/><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7.png"/><Relationship Id="rId5" Type="http://schemas.openxmlformats.org/officeDocument/2006/relationships/image" Target="../media/image3.tiff"/><Relationship Id="rId15" Type="http://schemas.openxmlformats.org/officeDocument/2006/relationships/image" Target="../media/image9.png"/><Relationship Id="rId10" Type="http://schemas.openxmlformats.org/officeDocument/2006/relationships/image" Target="../media/image6.tiff"/><Relationship Id="rId4" Type="http://schemas.openxmlformats.org/officeDocument/2006/relationships/image" Target="../media/image2.tiff"/><Relationship Id="rId9" Type="http://schemas.microsoft.com/office/2007/relationships/hdphoto" Target="../media/hdphoto2.wdp"/><Relationship Id="rId14" Type="http://schemas.microsoft.com/office/2007/relationships/hdphoto" Target="../media/hdphoto4.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EF7220AD-9458-4B13-9101-12BFA96A1810}"/>
              </a:ext>
            </a:extLst>
          </p:cNvPr>
          <p:cNvGrpSpPr/>
          <p:nvPr/>
        </p:nvGrpSpPr>
        <p:grpSpPr>
          <a:xfrm>
            <a:off x="186589" y="1422466"/>
            <a:ext cx="6484822" cy="8377632"/>
            <a:chOff x="-1115531" y="419113"/>
            <a:chExt cx="6773558" cy="8750647"/>
          </a:xfrm>
        </p:grpSpPr>
        <p:sp>
          <p:nvSpPr>
            <p:cNvPr id="7" name="TextBox 6">
              <a:extLst>
                <a:ext uri="{FF2B5EF4-FFF2-40B4-BE49-F238E27FC236}">
                  <a16:creationId xmlns:a16="http://schemas.microsoft.com/office/drawing/2014/main" id="{65344804-014D-4F7F-89BE-8FDBDC89E59A}"/>
                </a:ext>
              </a:extLst>
            </p:cNvPr>
            <p:cNvSpPr txBox="1"/>
            <p:nvPr/>
          </p:nvSpPr>
          <p:spPr>
            <a:xfrm rot="16200000">
              <a:off x="-42479" y="7068312"/>
              <a:ext cx="922736" cy="26346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IgG Control</a:t>
              </a:r>
            </a:p>
          </p:txBody>
        </p:sp>
        <p:sp>
          <p:nvSpPr>
            <p:cNvPr id="8" name="TextBox 7">
              <a:extLst>
                <a:ext uri="{FF2B5EF4-FFF2-40B4-BE49-F238E27FC236}">
                  <a16:creationId xmlns:a16="http://schemas.microsoft.com/office/drawing/2014/main" id="{08887007-58A9-4043-A9A2-D0CC96D1F9D6}"/>
                </a:ext>
              </a:extLst>
            </p:cNvPr>
            <p:cNvSpPr txBox="1"/>
            <p:nvPr/>
          </p:nvSpPr>
          <p:spPr>
            <a:xfrm rot="16200000">
              <a:off x="156491" y="8503163"/>
              <a:ext cx="524795" cy="26346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BsAb</a:t>
              </a:r>
            </a:p>
          </p:txBody>
        </p:sp>
        <p:sp>
          <p:nvSpPr>
            <p:cNvPr id="27" name="TextBox 26">
              <a:extLst>
                <a:ext uri="{FF2B5EF4-FFF2-40B4-BE49-F238E27FC236}">
                  <a16:creationId xmlns:a16="http://schemas.microsoft.com/office/drawing/2014/main" id="{AFD89C10-828B-4348-9400-D3F10865C33A}"/>
                </a:ext>
              </a:extLst>
            </p:cNvPr>
            <p:cNvSpPr txBox="1"/>
            <p:nvPr/>
          </p:nvSpPr>
          <p:spPr>
            <a:xfrm>
              <a:off x="-1115531" y="7422008"/>
              <a:ext cx="1286334" cy="67510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200" dirty="0">
                  <a:solidFill>
                    <a:prstClr val="black"/>
                  </a:solidFill>
                  <a:latin typeface="Arial" panose="020B0604020202020204" pitchFamily="34" charset="0"/>
                  <a:cs typeface="Arial" panose="020B0604020202020204" pitchFamily="34" charset="0"/>
                </a:rPr>
                <a:t>Primary human f</a:t>
              </a:r>
              <a:r>
                <a:rPr kumimoji="0" lang="en-US" sz="1200" b="0" i="0" u="none" strike="noStrike" kern="120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ibrotic</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lung fibroblasts</a:t>
              </a:r>
            </a:p>
          </p:txBody>
        </p:sp>
        <p:pic>
          <p:nvPicPr>
            <p:cNvPr id="49" name="Picture 48">
              <a:extLst>
                <a:ext uri="{FF2B5EF4-FFF2-40B4-BE49-F238E27FC236}">
                  <a16:creationId xmlns:a16="http://schemas.microsoft.com/office/drawing/2014/main" id="{D6E85C12-BFDD-4BEA-AEA9-8FB8BDDFA099}"/>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611663" y="6532091"/>
              <a:ext cx="1286334" cy="1286334"/>
            </a:xfrm>
            <a:prstGeom prst="rect">
              <a:avLst/>
            </a:prstGeom>
          </p:spPr>
        </p:pic>
        <p:pic>
          <p:nvPicPr>
            <p:cNvPr id="45" name="Picture 44">
              <a:extLst>
                <a:ext uri="{FF2B5EF4-FFF2-40B4-BE49-F238E27FC236}">
                  <a16:creationId xmlns:a16="http://schemas.microsoft.com/office/drawing/2014/main" id="{E5BF901F-73B1-4866-B87E-A2921145A5D4}"/>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3308547" y="7873786"/>
              <a:ext cx="1286333" cy="1286334"/>
            </a:xfrm>
            <a:prstGeom prst="rect">
              <a:avLst/>
            </a:prstGeom>
          </p:spPr>
        </p:pic>
        <p:pic>
          <p:nvPicPr>
            <p:cNvPr id="46" name="Picture 45">
              <a:extLst>
                <a:ext uri="{FF2B5EF4-FFF2-40B4-BE49-F238E27FC236}">
                  <a16:creationId xmlns:a16="http://schemas.microsoft.com/office/drawing/2014/main" id="{D63FE4B1-4A92-4060-97D4-2DCCFD5A0A57}"/>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611663" y="7883426"/>
              <a:ext cx="1286333" cy="1286334"/>
            </a:xfrm>
            <a:prstGeom prst="rect">
              <a:avLst/>
            </a:prstGeom>
          </p:spPr>
        </p:pic>
        <p:pic>
          <p:nvPicPr>
            <p:cNvPr id="47" name="Picture 46">
              <a:extLst>
                <a:ext uri="{FF2B5EF4-FFF2-40B4-BE49-F238E27FC236}">
                  <a16:creationId xmlns:a16="http://schemas.microsoft.com/office/drawing/2014/main" id="{CC3F405E-00F9-49AE-834F-8D02BC0DEDDB}"/>
                </a:ext>
              </a:extLst>
            </p:cNvPr>
            <p:cNvPicPr>
              <a:picLocks noChangeAspect="1"/>
            </p:cNvPicPr>
            <p:nvPr/>
          </p:nvPicPr>
          <p:blipFill>
            <a:blip r:embed="rId6" cstate="hq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1960106" y="7873785"/>
              <a:ext cx="1286333" cy="1286334"/>
            </a:xfrm>
            <a:prstGeom prst="rect">
              <a:avLst/>
            </a:prstGeom>
          </p:spPr>
        </p:pic>
        <p:pic>
          <p:nvPicPr>
            <p:cNvPr id="54" name="Picture 53">
              <a:extLst>
                <a:ext uri="{FF2B5EF4-FFF2-40B4-BE49-F238E27FC236}">
                  <a16:creationId xmlns:a16="http://schemas.microsoft.com/office/drawing/2014/main" id="{96DAD91F-5FD9-4B38-8EA7-D2D986C34E88}"/>
                </a:ext>
              </a:extLst>
            </p:cNvPr>
            <p:cNvPicPr>
              <a:picLocks noChangeAspect="1"/>
            </p:cNvPicPr>
            <p:nvPr/>
          </p:nvPicPr>
          <p:blipFill>
            <a:blip r:embed="rId8" cstate="hqprint">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1970629" y="6532090"/>
              <a:ext cx="1286333" cy="1286334"/>
            </a:xfrm>
            <a:prstGeom prst="rect">
              <a:avLst/>
            </a:prstGeom>
          </p:spPr>
        </p:pic>
        <p:pic>
          <p:nvPicPr>
            <p:cNvPr id="58" name="Picture 57">
              <a:extLst>
                <a:ext uri="{FF2B5EF4-FFF2-40B4-BE49-F238E27FC236}">
                  <a16:creationId xmlns:a16="http://schemas.microsoft.com/office/drawing/2014/main" id="{3AD79D2C-BE67-4737-BD89-A0AB15F9DDF5}"/>
                </a:ext>
              </a:extLst>
            </p:cNvPr>
            <p:cNvPicPr>
              <a:picLocks noChangeAspect="1"/>
            </p:cNvPicPr>
            <p:nvPr/>
          </p:nvPicPr>
          <p:blipFill>
            <a:blip r:embed="rId10" cstate="hqprint">
              <a:extLst>
                <a:ext uri="{28A0092B-C50C-407E-A947-70E740481C1C}">
                  <a14:useLocalDpi xmlns:a14="http://schemas.microsoft.com/office/drawing/2010/main" val="0"/>
                </a:ext>
              </a:extLst>
            </a:blip>
            <a:stretch>
              <a:fillRect/>
            </a:stretch>
          </p:blipFill>
          <p:spPr>
            <a:xfrm>
              <a:off x="3308546" y="6532089"/>
              <a:ext cx="1286334" cy="1286335"/>
            </a:xfrm>
            <a:prstGeom prst="rect">
              <a:avLst/>
            </a:prstGeom>
          </p:spPr>
        </p:pic>
        <p:cxnSp>
          <p:nvCxnSpPr>
            <p:cNvPr id="61" name="Straight Connector 60">
              <a:extLst>
                <a:ext uri="{FF2B5EF4-FFF2-40B4-BE49-F238E27FC236}">
                  <a16:creationId xmlns:a16="http://schemas.microsoft.com/office/drawing/2014/main" id="{60770B83-1127-4F2D-B417-7730032C6158}"/>
                </a:ext>
              </a:extLst>
            </p:cNvPr>
            <p:cNvCxnSpPr/>
            <p:nvPr/>
          </p:nvCxnSpPr>
          <p:spPr>
            <a:xfrm>
              <a:off x="4670668" y="7359645"/>
              <a:ext cx="199311" cy="0"/>
            </a:xfrm>
            <a:prstGeom prst="line">
              <a:avLst/>
            </a:prstGeom>
          </p:spPr>
          <p:style>
            <a:lnRef idx="2">
              <a:schemeClr val="accent1"/>
            </a:lnRef>
            <a:fillRef idx="0">
              <a:schemeClr val="accent1"/>
            </a:fillRef>
            <a:effectRef idx="1">
              <a:schemeClr val="accent1"/>
            </a:effectRef>
            <a:fontRef idx="minor">
              <a:schemeClr val="tx1"/>
            </a:fontRef>
          </p:style>
        </p:cxnSp>
        <p:sp>
          <p:nvSpPr>
            <p:cNvPr id="62" name="TextBox 61">
              <a:extLst>
                <a:ext uri="{FF2B5EF4-FFF2-40B4-BE49-F238E27FC236}">
                  <a16:creationId xmlns:a16="http://schemas.microsoft.com/office/drawing/2014/main" id="{108CAF4E-2AB6-4B17-9E6F-F1E346041C65}"/>
                </a:ext>
              </a:extLst>
            </p:cNvPr>
            <p:cNvSpPr txBox="1"/>
            <p:nvPr/>
          </p:nvSpPr>
          <p:spPr>
            <a:xfrm>
              <a:off x="4577236" y="7364406"/>
              <a:ext cx="1080791" cy="301139"/>
            </a:xfrm>
            <a:prstGeom prst="rect">
              <a:avLst/>
            </a:prstGeom>
            <a:noFill/>
          </p:spPr>
          <p:txBody>
            <a:bodyPr wrap="square" rtlCol="0">
              <a:spAutoFit/>
            </a:bodyPr>
            <a:lstStyle/>
            <a:p>
              <a:pPr marL="0" marR="0" lvl="0" indent="0"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100 </a:t>
              </a:r>
              <a:r>
                <a:rPr kumimoji="0" lang="el-GR"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μ</a:t>
              </a:r>
              <a:r>
                <a:rPr kumimoji="0" lang="en-US"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m</a:t>
              </a:r>
            </a:p>
          </p:txBody>
        </p:sp>
        <p:sp>
          <p:nvSpPr>
            <p:cNvPr id="63" name="TextBox 62">
              <a:extLst>
                <a:ext uri="{FF2B5EF4-FFF2-40B4-BE49-F238E27FC236}">
                  <a16:creationId xmlns:a16="http://schemas.microsoft.com/office/drawing/2014/main" id="{511BFF64-48D6-483A-8213-539471607A7B}"/>
                </a:ext>
              </a:extLst>
            </p:cNvPr>
            <p:cNvSpPr txBox="1"/>
            <p:nvPr/>
          </p:nvSpPr>
          <p:spPr>
            <a:xfrm>
              <a:off x="4594880" y="6540136"/>
              <a:ext cx="859502" cy="702659"/>
            </a:xfrm>
            <a:prstGeom prst="rect">
              <a:avLst/>
            </a:prstGeom>
            <a:noFill/>
          </p:spPr>
          <p:txBody>
            <a:bodyPr wrap="none" rtlCol="0">
              <a:spAutoFit/>
            </a:bodyPr>
            <a:lstStyle/>
            <a:p>
              <a:r>
                <a:rPr lang="en-US" sz="1200" b="1">
                  <a:solidFill>
                    <a:schemeClr val="accent6"/>
                  </a:solidFill>
                  <a:latin typeface="Arial" panose="020B0604020202020204" pitchFamily="34" charset="0"/>
                  <a:cs typeface="Arial" panose="020B0604020202020204" pitchFamily="34" charset="0"/>
                </a:rPr>
                <a:t>FN</a:t>
              </a:r>
            </a:p>
            <a:p>
              <a:r>
                <a:rPr lang="en-US" sz="1200" b="1">
                  <a:solidFill>
                    <a:srgbClr val="FF0000"/>
                  </a:solidFill>
                  <a:latin typeface="Arial" panose="020B0604020202020204" pitchFamily="34" charset="0"/>
                  <a:cs typeface="Arial" panose="020B0604020202020204" pitchFamily="34" charset="0"/>
                </a:rPr>
                <a:t>COL1A1</a:t>
              </a:r>
            </a:p>
            <a:p>
              <a:r>
                <a:rPr lang="en-US" sz="1200" b="1">
                  <a:solidFill>
                    <a:srgbClr val="0070C0"/>
                  </a:solidFill>
                  <a:latin typeface="Arial" panose="020B0604020202020204" pitchFamily="34" charset="0"/>
                  <a:cs typeface="Arial" panose="020B0604020202020204" pitchFamily="34" charset="0"/>
                </a:rPr>
                <a:t>DAPI</a:t>
              </a:r>
              <a:endParaRPr lang="en-US" sz="1200" b="1">
                <a:solidFill>
                  <a:srgbClr val="FF0000"/>
                </a:solidFill>
                <a:latin typeface="Arial" panose="020B0604020202020204" pitchFamily="34" charset="0"/>
                <a:cs typeface="Arial" panose="020B0604020202020204" pitchFamily="34" charset="0"/>
              </a:endParaRPr>
            </a:p>
          </p:txBody>
        </p:sp>
        <p:pic>
          <p:nvPicPr>
            <p:cNvPr id="19" name="Picture 18">
              <a:extLst>
                <a:ext uri="{FF2B5EF4-FFF2-40B4-BE49-F238E27FC236}">
                  <a16:creationId xmlns:a16="http://schemas.microsoft.com/office/drawing/2014/main" id="{27EEF4B6-3B61-44D0-85D1-A7E062BA449C}"/>
                </a:ext>
              </a:extLst>
            </p:cNvPr>
            <p:cNvPicPr>
              <a:picLocks noChangeAspect="1"/>
            </p:cNvPicPr>
            <p:nvPr/>
          </p:nvPicPr>
          <p:blipFill rotWithShape="1">
            <a:blip r:embed="rId11">
              <a:extLst>
                <a:ext uri="{BEBA8EAE-BF5A-486C-A8C5-ECC9F3942E4B}">
                  <a14:imgProps xmlns:a14="http://schemas.microsoft.com/office/drawing/2010/main">
                    <a14:imgLayer r:embed="rId12">
                      <a14:imgEffect>
                        <a14:brightnessContrast bright="40000" contrast="40000"/>
                      </a14:imgEffect>
                    </a14:imgLayer>
                  </a14:imgProps>
                </a:ext>
              </a:extLst>
            </a:blip>
            <a:srcRect l="24798"/>
            <a:stretch/>
          </p:blipFill>
          <p:spPr>
            <a:xfrm>
              <a:off x="602205" y="1847829"/>
              <a:ext cx="4020932" cy="1330435"/>
            </a:xfrm>
            <a:prstGeom prst="rect">
              <a:avLst/>
            </a:prstGeom>
          </p:spPr>
        </p:pic>
        <p:sp>
          <p:nvSpPr>
            <p:cNvPr id="20" name="TextBox 19">
              <a:extLst>
                <a:ext uri="{FF2B5EF4-FFF2-40B4-BE49-F238E27FC236}">
                  <a16:creationId xmlns:a16="http://schemas.microsoft.com/office/drawing/2014/main" id="{6881229C-7153-4EB2-8DAA-13FD4A567142}"/>
                </a:ext>
              </a:extLst>
            </p:cNvPr>
            <p:cNvSpPr txBox="1"/>
            <p:nvPr/>
          </p:nvSpPr>
          <p:spPr>
            <a:xfrm>
              <a:off x="-1061833" y="1360276"/>
              <a:ext cx="1375589" cy="867997"/>
            </a:xfrm>
            <a:prstGeom prst="rect">
              <a:avLst/>
            </a:prstGeom>
            <a:noFill/>
          </p:spPr>
          <p:txBody>
            <a:bodyPr wrap="square" rtlCol="0">
              <a:spAutoFit/>
            </a:bodyPr>
            <a:lstStyle/>
            <a:p>
              <a:pPr algn="ctr"/>
              <a:r>
                <a:rPr lang="en-US" sz="1200" dirty="0">
                  <a:solidFill>
                    <a:prstClr val="black"/>
                  </a:solidFill>
                  <a:latin typeface="Arial" panose="020B0604020202020204" pitchFamily="34" charset="0"/>
                  <a:cs typeface="Arial" panose="020B0604020202020204" pitchFamily="34" charset="0"/>
                </a:rPr>
                <a:t> Primary human fibrotic liver stellate cells (HL181010)</a:t>
              </a:r>
              <a:endParaRPr lang="en-US" dirty="0"/>
            </a:p>
          </p:txBody>
        </p:sp>
        <p:pic>
          <p:nvPicPr>
            <p:cNvPr id="21" name="Picture 20">
              <a:extLst>
                <a:ext uri="{FF2B5EF4-FFF2-40B4-BE49-F238E27FC236}">
                  <a16:creationId xmlns:a16="http://schemas.microsoft.com/office/drawing/2014/main" id="{FD23F2EB-CD30-4B78-8347-E59C22718A82}"/>
                </a:ext>
              </a:extLst>
            </p:cNvPr>
            <p:cNvPicPr>
              <a:picLocks noChangeAspect="1"/>
            </p:cNvPicPr>
            <p:nvPr/>
          </p:nvPicPr>
          <p:blipFill rotWithShape="1">
            <a:blip r:embed="rId13">
              <a:extLst>
                <a:ext uri="{BEBA8EAE-BF5A-486C-A8C5-ECC9F3942E4B}">
                  <a14:imgProps xmlns:a14="http://schemas.microsoft.com/office/drawing/2010/main">
                    <a14:imgLayer r:embed="rId14">
                      <a14:imgEffect>
                        <a14:brightnessContrast bright="40000" contrast="40000"/>
                      </a14:imgEffect>
                    </a14:imgLayer>
                  </a14:imgProps>
                </a:ext>
              </a:extLst>
            </a:blip>
            <a:srcRect l="24798"/>
            <a:stretch/>
          </p:blipFill>
          <p:spPr>
            <a:xfrm>
              <a:off x="602205" y="456868"/>
              <a:ext cx="4020932" cy="1337407"/>
            </a:xfrm>
            <a:prstGeom prst="rect">
              <a:avLst/>
            </a:prstGeom>
          </p:spPr>
        </p:pic>
        <p:sp>
          <p:nvSpPr>
            <p:cNvPr id="25" name="TextBox 24">
              <a:extLst>
                <a:ext uri="{FF2B5EF4-FFF2-40B4-BE49-F238E27FC236}">
                  <a16:creationId xmlns:a16="http://schemas.microsoft.com/office/drawing/2014/main" id="{1739EE7F-4B26-492C-9A21-D8B4D53A95D3}"/>
                </a:ext>
              </a:extLst>
            </p:cNvPr>
            <p:cNvSpPr txBox="1"/>
            <p:nvPr/>
          </p:nvSpPr>
          <p:spPr>
            <a:xfrm rot="16200000">
              <a:off x="-42479" y="1052146"/>
              <a:ext cx="922735" cy="26346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gG Control</a:t>
              </a:r>
            </a:p>
          </p:txBody>
        </p:sp>
        <p:sp>
          <p:nvSpPr>
            <p:cNvPr id="26" name="TextBox 25">
              <a:extLst>
                <a:ext uri="{FF2B5EF4-FFF2-40B4-BE49-F238E27FC236}">
                  <a16:creationId xmlns:a16="http://schemas.microsoft.com/office/drawing/2014/main" id="{9F8B62C0-0701-4452-9ECE-E70CF3460A27}"/>
                </a:ext>
              </a:extLst>
            </p:cNvPr>
            <p:cNvSpPr txBox="1"/>
            <p:nvPr/>
          </p:nvSpPr>
          <p:spPr>
            <a:xfrm rot="16200000">
              <a:off x="156491" y="2486997"/>
              <a:ext cx="524795" cy="26346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BsAb</a:t>
              </a:r>
            </a:p>
          </p:txBody>
        </p:sp>
        <p:cxnSp>
          <p:nvCxnSpPr>
            <p:cNvPr id="65" name="Straight Connector 64">
              <a:extLst>
                <a:ext uri="{FF2B5EF4-FFF2-40B4-BE49-F238E27FC236}">
                  <a16:creationId xmlns:a16="http://schemas.microsoft.com/office/drawing/2014/main" id="{36869760-8BC8-400F-9233-EDB338402EF1}"/>
                </a:ext>
              </a:extLst>
            </p:cNvPr>
            <p:cNvCxnSpPr/>
            <p:nvPr/>
          </p:nvCxnSpPr>
          <p:spPr>
            <a:xfrm>
              <a:off x="4726758" y="1185798"/>
              <a:ext cx="249140" cy="0"/>
            </a:xfrm>
            <a:prstGeom prst="line">
              <a:avLst/>
            </a:prstGeom>
          </p:spPr>
          <p:style>
            <a:lnRef idx="2">
              <a:schemeClr val="accent1"/>
            </a:lnRef>
            <a:fillRef idx="0">
              <a:schemeClr val="accent1"/>
            </a:fillRef>
            <a:effectRef idx="1">
              <a:schemeClr val="accent1"/>
            </a:effectRef>
            <a:fontRef idx="minor">
              <a:schemeClr val="tx1"/>
            </a:fontRef>
          </p:style>
        </p:cxnSp>
        <p:sp>
          <p:nvSpPr>
            <p:cNvPr id="66" name="TextBox 65">
              <a:extLst>
                <a:ext uri="{FF2B5EF4-FFF2-40B4-BE49-F238E27FC236}">
                  <a16:creationId xmlns:a16="http://schemas.microsoft.com/office/drawing/2014/main" id="{B972A8FF-4AEE-45F4-8801-82D1725996E7}"/>
                </a:ext>
              </a:extLst>
            </p:cNvPr>
            <p:cNvSpPr txBox="1"/>
            <p:nvPr/>
          </p:nvSpPr>
          <p:spPr>
            <a:xfrm>
              <a:off x="4637342" y="1203786"/>
              <a:ext cx="748760" cy="263464"/>
            </a:xfrm>
            <a:prstGeom prst="rect">
              <a:avLst/>
            </a:prstGeom>
            <a:noFill/>
          </p:spPr>
          <p:txBody>
            <a:bodyPr wrap="square" rtlCol="0">
              <a:spAutoFit/>
            </a:bodyPr>
            <a:lstStyle/>
            <a:p>
              <a:pPr marL="0" marR="0" lvl="0" indent="0"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20 </a:t>
              </a:r>
              <a:r>
                <a:rPr kumimoji="0" lang="el-GR"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μ</a:t>
              </a:r>
              <a:r>
                <a:rPr kumimoji="0" lang="en-US"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m</a:t>
              </a:r>
            </a:p>
          </p:txBody>
        </p:sp>
        <p:sp>
          <p:nvSpPr>
            <p:cNvPr id="71" name="TextBox 70">
              <a:extLst>
                <a:ext uri="{FF2B5EF4-FFF2-40B4-BE49-F238E27FC236}">
                  <a16:creationId xmlns:a16="http://schemas.microsoft.com/office/drawing/2014/main" id="{BAD48846-1FF2-41CD-B750-B8CF8ED157F2}"/>
                </a:ext>
              </a:extLst>
            </p:cNvPr>
            <p:cNvSpPr txBox="1"/>
            <p:nvPr/>
          </p:nvSpPr>
          <p:spPr>
            <a:xfrm>
              <a:off x="4623134" y="419113"/>
              <a:ext cx="859502" cy="702659"/>
            </a:xfrm>
            <a:prstGeom prst="rect">
              <a:avLst/>
            </a:prstGeom>
            <a:noFill/>
          </p:spPr>
          <p:txBody>
            <a:bodyPr wrap="none" rtlCol="0">
              <a:spAutoFit/>
            </a:bodyPr>
            <a:lstStyle/>
            <a:p>
              <a:r>
                <a:rPr lang="en-US" sz="1200" b="1">
                  <a:solidFill>
                    <a:schemeClr val="accent6"/>
                  </a:solidFill>
                  <a:latin typeface="Arial" panose="020B0604020202020204" pitchFamily="34" charset="0"/>
                  <a:cs typeface="Arial" panose="020B0604020202020204" pitchFamily="34" charset="0"/>
                </a:rPr>
                <a:t>FN</a:t>
              </a:r>
            </a:p>
            <a:p>
              <a:r>
                <a:rPr lang="en-US" sz="1200" b="1">
                  <a:solidFill>
                    <a:srgbClr val="FF0000"/>
                  </a:solidFill>
                  <a:latin typeface="Arial" panose="020B0604020202020204" pitchFamily="34" charset="0"/>
                  <a:cs typeface="Arial" panose="020B0604020202020204" pitchFamily="34" charset="0"/>
                </a:rPr>
                <a:t>COL1A1</a:t>
              </a:r>
            </a:p>
            <a:p>
              <a:r>
                <a:rPr lang="en-US" sz="1200" b="1">
                  <a:solidFill>
                    <a:srgbClr val="0070C0"/>
                  </a:solidFill>
                  <a:latin typeface="Arial" panose="020B0604020202020204" pitchFamily="34" charset="0"/>
                  <a:cs typeface="Arial" panose="020B0604020202020204" pitchFamily="34" charset="0"/>
                </a:rPr>
                <a:t>DAPI</a:t>
              </a:r>
              <a:endParaRPr lang="en-US" sz="1200" b="1">
                <a:solidFill>
                  <a:srgbClr val="FF0000"/>
                </a:solidFill>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96BDDBF5-E0E9-4EDD-8442-02BF3C3A13F5}"/>
                </a:ext>
              </a:extLst>
            </p:cNvPr>
            <p:cNvSpPr txBox="1"/>
            <p:nvPr/>
          </p:nvSpPr>
          <p:spPr>
            <a:xfrm>
              <a:off x="-1092224" y="4395495"/>
              <a:ext cx="1336829" cy="867997"/>
            </a:xfrm>
            <a:prstGeom prst="rect">
              <a:avLst/>
            </a:prstGeom>
            <a:noFill/>
          </p:spPr>
          <p:txBody>
            <a:bodyPr wrap="square" rtlCol="0">
              <a:spAutoFit/>
            </a:bodyPr>
            <a:lstStyle/>
            <a:p>
              <a:pPr algn="ctr"/>
              <a:r>
                <a:rPr lang="en-US" sz="1200" dirty="0">
                  <a:solidFill>
                    <a:prstClr val="black"/>
                  </a:solidFill>
                  <a:latin typeface="Arial" panose="020B0604020202020204" pitchFamily="34" charset="0"/>
                  <a:cs typeface="Arial" panose="020B0604020202020204" pitchFamily="34" charset="0"/>
                </a:rPr>
                <a:t>Primary human fibrotic liver stellate cells (H230819)</a:t>
              </a:r>
              <a:endParaRPr lang="en-US" dirty="0"/>
            </a:p>
          </p:txBody>
        </p:sp>
        <p:sp>
          <p:nvSpPr>
            <p:cNvPr id="31" name="TextBox 30">
              <a:extLst>
                <a:ext uri="{FF2B5EF4-FFF2-40B4-BE49-F238E27FC236}">
                  <a16:creationId xmlns:a16="http://schemas.microsoft.com/office/drawing/2014/main" id="{7D00C1B0-C791-429C-AD61-4475D35B2BB9}"/>
                </a:ext>
              </a:extLst>
            </p:cNvPr>
            <p:cNvSpPr txBox="1"/>
            <p:nvPr/>
          </p:nvSpPr>
          <p:spPr>
            <a:xfrm rot="16200000">
              <a:off x="-42479" y="4056070"/>
              <a:ext cx="922735" cy="26346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IgG Control</a:t>
              </a:r>
            </a:p>
          </p:txBody>
        </p:sp>
        <p:sp>
          <p:nvSpPr>
            <p:cNvPr id="32" name="TextBox 31">
              <a:extLst>
                <a:ext uri="{FF2B5EF4-FFF2-40B4-BE49-F238E27FC236}">
                  <a16:creationId xmlns:a16="http://schemas.microsoft.com/office/drawing/2014/main" id="{4B4C88B7-534D-4392-8B45-CD4DBD0E06DC}"/>
                </a:ext>
              </a:extLst>
            </p:cNvPr>
            <p:cNvSpPr txBox="1"/>
            <p:nvPr/>
          </p:nvSpPr>
          <p:spPr>
            <a:xfrm rot="16200000">
              <a:off x="156491" y="5490922"/>
              <a:ext cx="524795" cy="26346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BsAb</a:t>
              </a:r>
            </a:p>
          </p:txBody>
        </p:sp>
        <p:grpSp>
          <p:nvGrpSpPr>
            <p:cNvPr id="35" name="Group 34">
              <a:extLst>
                <a:ext uri="{FF2B5EF4-FFF2-40B4-BE49-F238E27FC236}">
                  <a16:creationId xmlns:a16="http://schemas.microsoft.com/office/drawing/2014/main" id="{056DD648-E1CF-4B28-A93C-9EA63B3183AD}"/>
                </a:ext>
              </a:extLst>
            </p:cNvPr>
            <p:cNvGrpSpPr/>
            <p:nvPr/>
          </p:nvGrpSpPr>
          <p:grpSpPr>
            <a:xfrm>
              <a:off x="602205" y="3485765"/>
              <a:ext cx="4024905" cy="2715854"/>
              <a:chOff x="1965763" y="7655066"/>
              <a:chExt cx="4612855" cy="3112581"/>
            </a:xfrm>
          </p:grpSpPr>
          <p:pic>
            <p:nvPicPr>
              <p:cNvPr id="33" name="Picture 32">
                <a:extLst>
                  <a:ext uri="{FF2B5EF4-FFF2-40B4-BE49-F238E27FC236}">
                    <a16:creationId xmlns:a16="http://schemas.microsoft.com/office/drawing/2014/main" id="{9E6D38F8-23B8-45D5-B0CC-C44C332D7D3F}"/>
                  </a:ext>
                </a:extLst>
              </p:cNvPr>
              <p:cNvPicPr>
                <a:picLocks noChangeAspect="1"/>
              </p:cNvPicPr>
              <p:nvPr/>
            </p:nvPicPr>
            <p:blipFill rotWithShape="1">
              <a:blip r:embed="rId15">
                <a:extLst>
                  <a:ext uri="{BEBA8EAE-BF5A-486C-A8C5-ECC9F3942E4B}">
                    <a14:imgProps xmlns:a14="http://schemas.microsoft.com/office/drawing/2010/main">
                      <a14:imgLayer r:embed="rId16">
                        <a14:imgEffect>
                          <a14:brightnessContrast bright="40000" contrast="40000"/>
                        </a14:imgEffect>
                      </a14:imgLayer>
                    </a14:imgProps>
                  </a:ext>
                </a:extLst>
              </a:blip>
              <a:srcRect l="24724"/>
              <a:stretch/>
            </p:blipFill>
            <p:spPr>
              <a:xfrm>
                <a:off x="1965763" y="7655066"/>
                <a:ext cx="4612855" cy="1528782"/>
              </a:xfrm>
              <a:prstGeom prst="rect">
                <a:avLst/>
              </a:prstGeom>
            </p:spPr>
          </p:pic>
          <p:pic>
            <p:nvPicPr>
              <p:cNvPr id="34" name="Picture 33">
                <a:extLst>
                  <a:ext uri="{FF2B5EF4-FFF2-40B4-BE49-F238E27FC236}">
                    <a16:creationId xmlns:a16="http://schemas.microsoft.com/office/drawing/2014/main" id="{93569E7A-E8E5-4753-AB19-848FFFB467CC}"/>
                  </a:ext>
                </a:extLst>
              </p:cNvPr>
              <p:cNvPicPr>
                <a:picLocks noChangeAspect="1"/>
              </p:cNvPicPr>
              <p:nvPr/>
            </p:nvPicPr>
            <p:blipFill rotWithShape="1">
              <a:blip r:embed="rId17">
                <a:extLst>
                  <a:ext uri="{BEBA8EAE-BF5A-486C-A8C5-ECC9F3942E4B}">
                    <a14:imgProps xmlns:a14="http://schemas.microsoft.com/office/drawing/2010/main">
                      <a14:imgLayer r:embed="rId18">
                        <a14:imgEffect>
                          <a14:brightnessContrast bright="40000" contrast="40000"/>
                        </a14:imgEffect>
                      </a14:imgLayer>
                    </a14:imgProps>
                  </a:ext>
                </a:extLst>
              </a:blip>
              <a:srcRect l="24724"/>
              <a:stretch/>
            </p:blipFill>
            <p:spPr>
              <a:xfrm>
                <a:off x="1965763" y="9248438"/>
                <a:ext cx="4612855" cy="1519209"/>
              </a:xfrm>
              <a:prstGeom prst="rect">
                <a:avLst/>
              </a:prstGeom>
            </p:spPr>
          </p:pic>
        </p:grpSp>
        <p:cxnSp>
          <p:nvCxnSpPr>
            <p:cNvPr id="68" name="Straight Connector 67">
              <a:extLst>
                <a:ext uri="{FF2B5EF4-FFF2-40B4-BE49-F238E27FC236}">
                  <a16:creationId xmlns:a16="http://schemas.microsoft.com/office/drawing/2014/main" id="{8162CB15-C774-43CB-8E29-6C531374815F}"/>
                </a:ext>
              </a:extLst>
            </p:cNvPr>
            <p:cNvCxnSpPr/>
            <p:nvPr/>
          </p:nvCxnSpPr>
          <p:spPr>
            <a:xfrm>
              <a:off x="4684286" y="4351667"/>
              <a:ext cx="312557" cy="0"/>
            </a:xfrm>
            <a:prstGeom prst="line">
              <a:avLst/>
            </a:prstGeom>
          </p:spPr>
          <p:style>
            <a:lnRef idx="2">
              <a:schemeClr val="accent1"/>
            </a:lnRef>
            <a:fillRef idx="0">
              <a:schemeClr val="accent1"/>
            </a:fillRef>
            <a:effectRef idx="1">
              <a:schemeClr val="accent1"/>
            </a:effectRef>
            <a:fontRef idx="minor">
              <a:schemeClr val="tx1"/>
            </a:fontRef>
          </p:style>
        </p:cxnSp>
        <p:sp>
          <p:nvSpPr>
            <p:cNvPr id="69" name="TextBox 68">
              <a:extLst>
                <a:ext uri="{FF2B5EF4-FFF2-40B4-BE49-F238E27FC236}">
                  <a16:creationId xmlns:a16="http://schemas.microsoft.com/office/drawing/2014/main" id="{7818342E-B8CF-47E2-93C2-646CD55FFAA5}"/>
                </a:ext>
              </a:extLst>
            </p:cNvPr>
            <p:cNvSpPr txBox="1"/>
            <p:nvPr/>
          </p:nvSpPr>
          <p:spPr>
            <a:xfrm>
              <a:off x="4601516" y="4377656"/>
              <a:ext cx="748759" cy="263464"/>
            </a:xfrm>
            <a:prstGeom prst="rect">
              <a:avLst/>
            </a:prstGeom>
            <a:noFill/>
          </p:spPr>
          <p:txBody>
            <a:bodyPr wrap="square" rtlCol="0">
              <a:spAutoFit/>
            </a:bodyPr>
            <a:lstStyle/>
            <a:p>
              <a:pPr marL="0" marR="0" lvl="0" indent="0"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50 </a:t>
              </a:r>
              <a:r>
                <a:rPr kumimoji="0" lang="el-GR"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μ</a:t>
              </a:r>
              <a:r>
                <a:rPr kumimoji="0" lang="en-US" sz="12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m</a:t>
              </a:r>
            </a:p>
          </p:txBody>
        </p:sp>
        <p:sp>
          <p:nvSpPr>
            <p:cNvPr id="72" name="TextBox 71">
              <a:extLst>
                <a:ext uri="{FF2B5EF4-FFF2-40B4-BE49-F238E27FC236}">
                  <a16:creationId xmlns:a16="http://schemas.microsoft.com/office/drawing/2014/main" id="{0B7EA0DE-D9AC-44F8-A250-58B0B4C4310A}"/>
                </a:ext>
              </a:extLst>
            </p:cNvPr>
            <p:cNvSpPr txBox="1"/>
            <p:nvPr/>
          </p:nvSpPr>
          <p:spPr>
            <a:xfrm>
              <a:off x="4646793" y="3507940"/>
              <a:ext cx="859501" cy="702659"/>
            </a:xfrm>
            <a:prstGeom prst="rect">
              <a:avLst/>
            </a:prstGeom>
            <a:noFill/>
          </p:spPr>
          <p:txBody>
            <a:bodyPr wrap="none" rtlCol="0">
              <a:spAutoFit/>
            </a:bodyPr>
            <a:lstStyle/>
            <a:p>
              <a:r>
                <a:rPr lang="en-US" sz="1200" b="1">
                  <a:solidFill>
                    <a:schemeClr val="accent6"/>
                  </a:solidFill>
                  <a:latin typeface="Arial" panose="020B0604020202020204" pitchFamily="34" charset="0"/>
                  <a:cs typeface="Arial" panose="020B0604020202020204" pitchFamily="34" charset="0"/>
                </a:rPr>
                <a:t>FN</a:t>
              </a:r>
            </a:p>
            <a:p>
              <a:r>
                <a:rPr lang="en-US" sz="1200" b="1">
                  <a:solidFill>
                    <a:srgbClr val="FF0000"/>
                  </a:solidFill>
                  <a:latin typeface="Arial" panose="020B0604020202020204" pitchFamily="34" charset="0"/>
                  <a:cs typeface="Arial" panose="020B0604020202020204" pitchFamily="34" charset="0"/>
                </a:rPr>
                <a:t>COL1A1</a:t>
              </a:r>
            </a:p>
            <a:p>
              <a:r>
                <a:rPr lang="en-US" sz="1200" b="1">
                  <a:solidFill>
                    <a:srgbClr val="0070C0"/>
                  </a:solidFill>
                  <a:latin typeface="Arial" panose="020B0604020202020204" pitchFamily="34" charset="0"/>
                  <a:cs typeface="Arial" panose="020B0604020202020204" pitchFamily="34" charset="0"/>
                </a:rPr>
                <a:t>DAPI</a:t>
              </a:r>
              <a:endParaRPr lang="en-US" sz="1200" b="1">
                <a:solidFill>
                  <a:srgbClr val="FF0000"/>
                </a:solidFill>
                <a:latin typeface="Arial" panose="020B0604020202020204" pitchFamily="34" charset="0"/>
                <a:cs typeface="Arial" panose="020B0604020202020204" pitchFamily="34" charset="0"/>
              </a:endParaRPr>
            </a:p>
          </p:txBody>
        </p:sp>
      </p:grpSp>
      <p:sp>
        <p:nvSpPr>
          <p:cNvPr id="3" name="Rectangle 2">
            <a:extLst>
              <a:ext uri="{FF2B5EF4-FFF2-40B4-BE49-F238E27FC236}">
                <a16:creationId xmlns:a16="http://schemas.microsoft.com/office/drawing/2014/main" id="{442AB1F2-5941-4F44-AC8D-E4A87AD7535C}"/>
              </a:ext>
            </a:extLst>
          </p:cNvPr>
          <p:cNvSpPr/>
          <p:nvPr/>
        </p:nvSpPr>
        <p:spPr>
          <a:xfrm>
            <a:off x="129201" y="105902"/>
            <a:ext cx="6599598" cy="1042850"/>
          </a:xfrm>
          <a:prstGeom prst="rect">
            <a:avLst/>
          </a:prstGeom>
        </p:spPr>
        <p:txBody>
          <a:bodyPr wrap="square">
            <a:spAutoFit/>
          </a:bodyPr>
          <a:lstStyle/>
          <a:p>
            <a:pPr>
              <a:lnSpc>
                <a:spcPct val="107000"/>
              </a:lnSpc>
              <a:spcAft>
                <a:spcPts val="800"/>
              </a:spcAft>
            </a:pPr>
            <a:r>
              <a:rPr lang="en-US" sz="1100" b="1" dirty="0">
                <a:latin typeface="Arial" panose="020B0604020202020204" pitchFamily="34" charset="0"/>
                <a:ea typeface="Calibri" panose="020F0502020204030204" pitchFamily="34" charset="0"/>
                <a:cs typeface="Times New Roman" panose="02020603050405020304" pitchFamily="18" charset="0"/>
              </a:rPr>
              <a:t>Supplementary Figure S4:  Effect of BsAb on primary fibroblasts isolated from patients with fibrotic disease</a:t>
            </a:r>
          </a:p>
          <a:p>
            <a:pPr>
              <a:lnSpc>
                <a:spcPct val="107000"/>
              </a:lnSpc>
              <a:spcAft>
                <a:spcPts val="800"/>
              </a:spcAft>
            </a:pPr>
            <a:r>
              <a:rPr lang="en-US" sz="1000" dirty="0">
                <a:latin typeface="Arial" panose="020B0604020202020204" pitchFamily="34" charset="0"/>
                <a:ea typeface="Calibri" panose="020F0502020204030204" pitchFamily="34" charset="0"/>
                <a:cs typeface="Times New Roman" panose="02020603050405020304" pitchFamily="18" charset="0"/>
              </a:rPr>
              <a:t>Primary fibroblasts isolated from patients with chronic fibrotic disease were treated with the IgG isotype control vs. bsAb.  After 72 hours, cells were fixed and immunofluorescence staining and confocal microscopy performed to evaluate the FN/COL matrix.  </a:t>
            </a:r>
            <a:endParaRPr lang="en-US" sz="10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0714087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2543e7ec-7072-4b75-829f-0ed03e19ff1e">
      <Terms xmlns="http://schemas.microsoft.com/office/infopath/2007/PartnerControls"/>
    </lcf76f155ced4ddcb4097134ff3c332f>
    <TaxCatchAll xmlns="57a0c4cc-3c09-49e8-920e-d8be8823b2ff"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A2F3B51C6BCD074793790340586B5297" ma:contentTypeVersion="18" ma:contentTypeDescription="Create a new document." ma:contentTypeScope="" ma:versionID="d8e7e0b6111b9d67775a07373b940835">
  <xsd:schema xmlns:xsd="http://www.w3.org/2001/XMLSchema" xmlns:xs="http://www.w3.org/2001/XMLSchema" xmlns:p="http://schemas.microsoft.com/office/2006/metadata/properties" xmlns:ns2="57a0c4cc-3c09-49e8-920e-d8be8823b2ff" xmlns:ns3="2543e7ec-7072-4b75-829f-0ed03e19ff1e" targetNamespace="http://schemas.microsoft.com/office/2006/metadata/properties" ma:root="true" ma:fieldsID="26eab72f2527c02910f532a8625ffb45" ns2:_="" ns3:_="">
    <xsd:import namespace="57a0c4cc-3c09-49e8-920e-d8be8823b2ff"/>
    <xsd:import namespace="2543e7ec-7072-4b75-829f-0ed03e19ff1e"/>
    <xsd:element name="properties">
      <xsd:complexType>
        <xsd:sequence>
          <xsd:element name="documentManagement">
            <xsd:complexType>
              <xsd:all>
                <xsd:element ref="ns2:SharedWithUsers" minOccurs="0"/>
                <xsd:element ref="ns2:SharedWithDetails" minOccurs="0"/>
                <xsd:element ref="ns3:MediaServiceMetadata" minOccurs="0"/>
                <xsd:element ref="ns3:MediaServiceFastMetadata" minOccurs="0"/>
                <xsd:element ref="ns3:MediaServiceDateTaken" minOccurs="0"/>
                <xsd:element ref="ns3:MediaServiceAutoTags" minOccurs="0"/>
                <xsd:element ref="ns3:MediaServiceOCR" minOccurs="0"/>
                <xsd:element ref="ns3:MediaServiceGenerationTime" minOccurs="0"/>
                <xsd:element ref="ns3:MediaServiceEventHashCode" minOccurs="0"/>
                <xsd:element ref="ns3:MediaServiceAutoKeyPoints" minOccurs="0"/>
                <xsd:element ref="ns3:MediaServiceKeyPoints" minOccurs="0"/>
                <xsd:element ref="ns3:MediaLengthInSeconds" minOccurs="0"/>
                <xsd:element ref="ns3:MediaServiceLocation" minOccurs="0"/>
                <xsd:element ref="ns3:lcf76f155ced4ddcb4097134ff3c332f" minOccurs="0"/>
                <xsd:element ref="ns2:TaxCatchAll" minOccurs="0"/>
                <xsd:element ref="ns3:MediaServiceObjectDetectorVersions" minOccurs="0"/>
                <xsd:element ref="ns3: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7a0c4cc-3c09-49e8-920e-d8be8823b2ff"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bfe539f8-3b21-43ac-9575-bd53185d5a89}" ma:internalName="TaxCatchAll" ma:showField="CatchAllData" ma:web="57a0c4cc-3c09-49e8-920e-d8be8823b2ff">
      <xsd:complexType>
        <xsd:complexContent>
          <xsd:extension base="dms:MultiChoiceLookup">
            <xsd:sequence>
              <xsd:element name="Value" type="dms:Lookup" maxOccurs="unbounded" minOccurs="0" nillable="true"/>
            </xsd:sequence>
          </xsd:extension>
        </xsd:complexContent>
      </xsd:complexType>
    </xsd:element>
  </xsd:schema>
  <xsd:schema xmlns:xsd="http://www.w3.org/2001/XMLSchema" xmlns:xs="http://www.w3.org/2001/XMLSchema" xmlns:dms="http://schemas.microsoft.com/office/2006/documentManagement/types" xmlns:pc="http://schemas.microsoft.com/office/infopath/2007/PartnerControls" targetNamespace="2543e7ec-7072-4b75-829f-0ed03e19ff1e" elementFormDefault="qualified">
    <xsd:import namespace="http://schemas.microsoft.com/office/2006/documentManagement/types"/>
    <xsd:import namespace="http://schemas.microsoft.com/office/infopath/2007/PartnerControls"/>
    <xsd:element name="MediaServiceMetadata" ma:index="10" nillable="true" ma:displayName="MediaServiceMetadata" ma:hidden="true" ma:internalName="MediaServiceMetadata" ma:readOnly="true">
      <xsd:simpleType>
        <xsd:restriction base="dms:Note"/>
      </xsd:simpleType>
    </xsd:element>
    <xsd:element name="MediaServiceFastMetadata" ma:index="11" nillable="true" ma:displayName="MediaServiceFastMetadata" ma:hidden="true" ma:internalName="MediaServiceFastMetadata" ma:readOnly="true">
      <xsd:simpleType>
        <xsd:restriction base="dms:Note"/>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3" nillable="true" ma:displayName="Tags" ma:internalName="MediaServiceAutoTags"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AutoKeyPoints" ma:index="17" nillable="true" ma:displayName="MediaServiceAutoKeyPoints" ma:hidden="true" ma:internalName="MediaServiceAutoKeyPoints" ma:readOnly="true">
      <xsd:simpleType>
        <xsd:restriction base="dms:Note"/>
      </xsd:simpleType>
    </xsd:element>
    <xsd:element name="MediaServiceKeyPoints" ma:index="18" nillable="true" ma:displayName="KeyPoints" ma:internalName="MediaServiceKeyPoints" ma:readOnly="true">
      <xsd:simpleType>
        <xsd:restriction base="dms:Note">
          <xsd:maxLength value="255"/>
        </xsd:restriction>
      </xsd:simpleType>
    </xsd:element>
    <xsd:element name="MediaLengthInSeconds" ma:index="19" nillable="true" ma:displayName="MediaLengthInSeconds" ma:hidden="true" ma:internalName="MediaLengthInSeconds" ma:readOnly="true">
      <xsd:simpleType>
        <xsd:restriction base="dms:Unknown"/>
      </xsd:simpleType>
    </xsd:element>
    <xsd:element name="MediaServiceLocation" ma:index="20" nillable="true" ma:displayName="Location" ma:internalName="MediaServiceLocation" ma:readOnly="true">
      <xsd:simpleType>
        <xsd:restriction base="dms:Text"/>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2ccd466c-82b6-42a3-8ba5-5c7db83406b1"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428AF018-5240-4F2F-B0A7-10A84DD9D260}">
  <ds:schemaRefs>
    <ds:schemaRef ds:uri="http://schemas.microsoft.com/sharepoint/v3/contenttype/forms"/>
  </ds:schemaRefs>
</ds:datastoreItem>
</file>

<file path=customXml/itemProps2.xml><?xml version="1.0" encoding="utf-8"?>
<ds:datastoreItem xmlns:ds="http://schemas.openxmlformats.org/officeDocument/2006/customXml" ds:itemID="{08778B21-93DC-4DE6-9C7D-29A88DF3DBC8}">
  <ds:schemaRefs>
    <ds:schemaRef ds:uri="http://schemas.microsoft.com/office/2006/metadata/properties"/>
    <ds:schemaRef ds:uri="http://purl.org/dc/terms/"/>
    <ds:schemaRef ds:uri="http://schemas.microsoft.com/office/2006/documentManagement/types"/>
    <ds:schemaRef ds:uri="http://purl.org/dc/dcmitype/"/>
    <ds:schemaRef ds:uri="57a0c4cc-3c09-49e8-920e-d8be8823b2ff"/>
    <ds:schemaRef ds:uri="http://purl.org/dc/elements/1.1/"/>
    <ds:schemaRef ds:uri="http://schemas.microsoft.com/office/infopath/2007/PartnerControls"/>
    <ds:schemaRef ds:uri="http://schemas.openxmlformats.org/package/2006/metadata/core-properties"/>
    <ds:schemaRef ds:uri="2543e7ec-7072-4b75-829f-0ed03e19ff1e"/>
    <ds:schemaRef ds:uri="http://www.w3.org/XML/1998/namespace"/>
  </ds:schemaRefs>
</ds:datastoreItem>
</file>

<file path=customXml/itemProps3.xml><?xml version="1.0" encoding="utf-8"?>
<ds:datastoreItem xmlns:ds="http://schemas.openxmlformats.org/officeDocument/2006/customXml" ds:itemID="{B01E279D-CEC9-47C5-B8DD-CF8E61B016A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7a0c4cc-3c09-49e8-920e-d8be8823b2ff"/>
    <ds:schemaRef ds:uri="2543e7ec-7072-4b75-829f-0ed03e19ff1e"/>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551</TotalTime>
  <Words>110</Words>
  <Application>Microsoft Office PowerPoint</Application>
  <PresentationFormat>A4 Paper (210x297 mm)</PresentationFormat>
  <Paragraphs>24</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ptos Display</vt:lpstr>
      <vt:lpstr>Arial</vt:lpstr>
      <vt:lpstr>Calibri</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u, Chengsheng</dc:creator>
  <cp:lastModifiedBy>Weis, Sara</cp:lastModifiedBy>
  <cp:revision>20</cp:revision>
  <dcterms:created xsi:type="dcterms:W3CDTF">2024-03-19T17:07:22Z</dcterms:created>
  <dcterms:modified xsi:type="dcterms:W3CDTF">2025-01-02T17:22: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2F3B51C6BCD074793790340586B5297</vt:lpwstr>
  </property>
  <property fmtid="{D5CDD505-2E9C-101B-9397-08002B2CF9AE}" pid="3" name="MediaServiceImageTags">
    <vt:lpwstr/>
  </property>
</Properties>
</file>